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70EBE4-5F25-2D45-8E98-26E458B7926F}" v="97" dt="2025-03-07T11:20:01.90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iara Napoletano" userId="3382be66-87d3-4f88-8936-a80a8def1550" providerId="ADAL" clId="{2870EBE4-5F25-2D45-8E98-26E458B7926F}"/>
    <pc:docChg chg="undo custSel addSld delSld modSld sldOrd">
      <pc:chgData name="Chiara Napoletano" userId="3382be66-87d3-4f88-8936-a80a8def1550" providerId="ADAL" clId="{2870EBE4-5F25-2D45-8E98-26E458B7926F}" dt="2025-03-07T11:29:06.931" v="2525" actId="2696"/>
      <pc:docMkLst>
        <pc:docMk/>
      </pc:docMkLst>
      <pc:sldChg chg="addSp delSp modSp mod ord modNotesTx">
        <pc:chgData name="Chiara Napoletano" userId="3382be66-87d3-4f88-8936-a80a8def1550" providerId="ADAL" clId="{2870EBE4-5F25-2D45-8E98-26E458B7926F}" dt="2025-03-07T09:24:39.316" v="2455" actId="20577"/>
        <pc:sldMkLst>
          <pc:docMk/>
          <pc:sldMk cId="21570610" sldId="256"/>
        </pc:sldMkLst>
        <pc:spChg chg="add mod">
          <ac:chgData name="Chiara Napoletano" userId="3382be66-87d3-4f88-8936-a80a8def1550" providerId="ADAL" clId="{2870EBE4-5F25-2D45-8E98-26E458B7926F}" dt="2025-02-26T14:14:35.869" v="1471" actId="255"/>
          <ac:spMkLst>
            <pc:docMk/>
            <pc:sldMk cId="21570610" sldId="256"/>
            <ac:spMk id="13" creationId="{1C382E00-0357-9D61-48C3-2CD25EC94E8A}"/>
          </ac:spMkLst>
        </pc:spChg>
        <pc:spChg chg="add mod">
          <ac:chgData name="Chiara Napoletano" userId="3382be66-87d3-4f88-8936-a80a8def1550" providerId="ADAL" clId="{2870EBE4-5F25-2D45-8E98-26E458B7926F}" dt="2025-02-26T14:14:35.869" v="1471" actId="255"/>
          <ac:spMkLst>
            <pc:docMk/>
            <pc:sldMk cId="21570610" sldId="256"/>
            <ac:spMk id="22" creationId="{5B5A8E81-63F5-F55C-BFBA-9690B4E48AFF}"/>
          </ac:spMkLst>
        </pc:spChg>
        <pc:spChg chg="add mod">
          <ac:chgData name="Chiara Napoletano" userId="3382be66-87d3-4f88-8936-a80a8def1550" providerId="ADAL" clId="{2870EBE4-5F25-2D45-8E98-26E458B7926F}" dt="2025-02-26T14:14:35.869" v="1471" actId="255"/>
          <ac:spMkLst>
            <pc:docMk/>
            <pc:sldMk cId="21570610" sldId="256"/>
            <ac:spMk id="26" creationId="{86764DE8-4A4D-5E86-6511-0AFC08E8C0B0}"/>
          </ac:spMkLst>
        </pc:spChg>
        <pc:spChg chg="add mod">
          <ac:chgData name="Chiara Napoletano" userId="3382be66-87d3-4f88-8936-a80a8def1550" providerId="ADAL" clId="{2870EBE4-5F25-2D45-8E98-26E458B7926F}" dt="2025-02-26T14:14:35.869" v="1471" actId="255"/>
          <ac:spMkLst>
            <pc:docMk/>
            <pc:sldMk cId="21570610" sldId="256"/>
            <ac:spMk id="27" creationId="{AB031FA8-CE6E-15D7-5BCF-840547E6CA3A}"/>
          </ac:spMkLst>
        </pc:spChg>
        <pc:spChg chg="add mod">
          <ac:chgData name="Chiara Napoletano" userId="3382be66-87d3-4f88-8936-a80a8def1550" providerId="ADAL" clId="{2870EBE4-5F25-2D45-8E98-26E458B7926F}" dt="2025-02-26T14:14:24.666" v="1470" actId="1037"/>
          <ac:spMkLst>
            <pc:docMk/>
            <pc:sldMk cId="21570610" sldId="256"/>
            <ac:spMk id="32" creationId="{85C5F08B-E828-57BA-BED8-7C6DCB2BA68B}"/>
          </ac:spMkLst>
        </pc:spChg>
        <pc:spChg chg="add mod">
          <ac:chgData name="Chiara Napoletano" userId="3382be66-87d3-4f88-8936-a80a8def1550" providerId="ADAL" clId="{2870EBE4-5F25-2D45-8E98-26E458B7926F}" dt="2025-03-07T09:24:39.316" v="2455" actId="20577"/>
          <ac:spMkLst>
            <pc:docMk/>
            <pc:sldMk cId="21570610" sldId="256"/>
            <ac:spMk id="33" creationId="{AF3C4FA6-8F50-9B33-91C3-9DF300E1FFB2}"/>
          </ac:spMkLst>
        </pc:spChg>
        <pc:spChg chg="add mod">
          <ac:chgData name="Chiara Napoletano" userId="3382be66-87d3-4f88-8936-a80a8def1550" providerId="ADAL" clId="{2870EBE4-5F25-2D45-8E98-26E458B7926F}" dt="2025-02-27T08:20:44.228" v="1512" actId="1035"/>
          <ac:spMkLst>
            <pc:docMk/>
            <pc:sldMk cId="21570610" sldId="256"/>
            <ac:spMk id="36" creationId="{1788D2B1-44E9-DE9F-BFE1-8D3E61A66179}"/>
          </ac:spMkLst>
        </pc:spChg>
        <pc:spChg chg="add mod">
          <ac:chgData name="Chiara Napoletano" userId="3382be66-87d3-4f88-8936-a80a8def1550" providerId="ADAL" clId="{2870EBE4-5F25-2D45-8E98-26E458B7926F}" dt="2025-02-27T08:20:52.389" v="1514" actId="20577"/>
          <ac:spMkLst>
            <pc:docMk/>
            <pc:sldMk cId="21570610" sldId="256"/>
            <ac:spMk id="37" creationId="{F4A8A9AC-D80D-B92A-294E-FDA04BB3ECE9}"/>
          </ac:spMkLst>
        </pc:spChg>
        <pc:picChg chg="add mod">
          <ac:chgData name="Chiara Napoletano" userId="3382be66-87d3-4f88-8936-a80a8def1550" providerId="ADAL" clId="{2870EBE4-5F25-2D45-8E98-26E458B7926F}" dt="2025-02-26T11:38:11.310" v="103" actId="1076"/>
          <ac:picMkLst>
            <pc:docMk/>
            <pc:sldMk cId="21570610" sldId="256"/>
            <ac:picMk id="2" creationId="{9778DD7C-F8A0-A7BA-5ED7-5384C18E0FA4}"/>
          </ac:picMkLst>
        </pc:picChg>
        <pc:picChg chg="add mod">
          <ac:chgData name="Chiara Napoletano" userId="3382be66-87d3-4f88-8936-a80a8def1550" providerId="ADAL" clId="{2870EBE4-5F25-2D45-8E98-26E458B7926F}" dt="2025-02-27T08:20:29.400" v="1496" actId="1076"/>
          <ac:picMkLst>
            <pc:docMk/>
            <pc:sldMk cId="21570610" sldId="256"/>
            <ac:picMk id="4" creationId="{ECE1299F-17C2-A5C2-6940-7EE54938F1F4}"/>
          </ac:picMkLst>
        </pc:picChg>
        <pc:picChg chg="add mod">
          <ac:chgData name="Chiara Napoletano" userId="3382be66-87d3-4f88-8936-a80a8def1550" providerId="ADAL" clId="{2870EBE4-5F25-2D45-8E98-26E458B7926F}" dt="2025-02-26T11:45:44.834" v="354" actId="1038"/>
          <ac:picMkLst>
            <pc:docMk/>
            <pc:sldMk cId="21570610" sldId="256"/>
            <ac:picMk id="5" creationId="{C405DC6C-7090-28D8-08FD-E6DB378A2FDF}"/>
          </ac:picMkLst>
        </pc:picChg>
        <pc:picChg chg="add mod">
          <ac:chgData name="Chiara Napoletano" userId="3382be66-87d3-4f88-8936-a80a8def1550" providerId="ADAL" clId="{2870EBE4-5F25-2D45-8E98-26E458B7926F}" dt="2025-02-26T11:45:44.834" v="354" actId="1038"/>
          <ac:picMkLst>
            <pc:docMk/>
            <pc:sldMk cId="21570610" sldId="256"/>
            <ac:picMk id="7" creationId="{F59C0085-DD4F-BE98-4887-6A1247746402}"/>
          </ac:picMkLst>
        </pc:picChg>
        <pc:picChg chg="add mod">
          <ac:chgData name="Chiara Napoletano" userId="3382be66-87d3-4f88-8936-a80a8def1550" providerId="ADAL" clId="{2870EBE4-5F25-2D45-8E98-26E458B7926F}" dt="2025-02-26T11:38:53.665" v="115" actId="1037"/>
          <ac:picMkLst>
            <pc:docMk/>
            <pc:sldMk cId="21570610" sldId="256"/>
            <ac:picMk id="8" creationId="{43AED657-0AD8-E555-4794-91CE3B19C253}"/>
          </ac:picMkLst>
        </pc:picChg>
        <pc:picChg chg="add mod">
          <ac:chgData name="Chiara Napoletano" userId="3382be66-87d3-4f88-8936-a80a8def1550" providerId="ADAL" clId="{2870EBE4-5F25-2D45-8E98-26E458B7926F}" dt="2025-02-26T11:45:44.834" v="354" actId="1038"/>
          <ac:picMkLst>
            <pc:docMk/>
            <pc:sldMk cId="21570610" sldId="256"/>
            <ac:picMk id="10" creationId="{00E1063F-9879-9E88-E2EA-BB7025742812}"/>
          </ac:picMkLst>
        </pc:picChg>
        <pc:picChg chg="add mod">
          <ac:chgData name="Chiara Napoletano" userId="3382be66-87d3-4f88-8936-a80a8def1550" providerId="ADAL" clId="{2870EBE4-5F25-2D45-8E98-26E458B7926F}" dt="2025-02-26T11:45:44.834" v="354" actId="1038"/>
          <ac:picMkLst>
            <pc:docMk/>
            <pc:sldMk cId="21570610" sldId="256"/>
            <ac:picMk id="11" creationId="{4B93EAA9-6710-955B-315F-8867E13413C2}"/>
          </ac:picMkLst>
        </pc:picChg>
        <pc:picChg chg="add mod">
          <ac:chgData name="Chiara Napoletano" userId="3382be66-87d3-4f88-8936-a80a8def1550" providerId="ADAL" clId="{2870EBE4-5F25-2D45-8E98-26E458B7926F}" dt="2025-02-26T11:45:44.834" v="354" actId="1038"/>
          <ac:picMkLst>
            <pc:docMk/>
            <pc:sldMk cId="21570610" sldId="256"/>
            <ac:picMk id="12" creationId="{063946D7-4F6A-5914-53E3-14AE4D7583CB}"/>
          </ac:picMkLst>
        </pc:picChg>
        <pc:cxnChg chg="add mod">
          <ac:chgData name="Chiara Napoletano" userId="3382be66-87d3-4f88-8936-a80a8def1550" providerId="ADAL" clId="{2870EBE4-5F25-2D45-8E98-26E458B7926F}" dt="2025-02-26T11:39:34.513" v="119" actId="13822"/>
          <ac:cxnSpMkLst>
            <pc:docMk/>
            <pc:sldMk cId="21570610" sldId="256"/>
            <ac:cxnSpMk id="19" creationId="{8C20AFE7-4DE5-589E-3CC2-34AEA3A4F854}"/>
          </ac:cxnSpMkLst>
        </pc:cxnChg>
        <pc:cxnChg chg="add mod">
          <ac:chgData name="Chiara Napoletano" userId="3382be66-87d3-4f88-8936-a80a8def1550" providerId="ADAL" clId="{2870EBE4-5F25-2D45-8E98-26E458B7926F}" dt="2025-02-26T11:39:43.897" v="121" actId="13822"/>
          <ac:cxnSpMkLst>
            <pc:docMk/>
            <pc:sldMk cId="21570610" sldId="256"/>
            <ac:cxnSpMk id="21" creationId="{23A7BEDD-5698-1CBB-3642-20B6599D240D}"/>
          </ac:cxnSpMkLst>
        </pc:cxnChg>
        <pc:cxnChg chg="add mod">
          <ac:chgData name="Chiara Napoletano" userId="3382be66-87d3-4f88-8936-a80a8def1550" providerId="ADAL" clId="{2870EBE4-5F25-2D45-8E98-26E458B7926F}" dt="2025-02-26T11:40:40.667" v="152" actId="1076"/>
          <ac:cxnSpMkLst>
            <pc:docMk/>
            <pc:sldMk cId="21570610" sldId="256"/>
            <ac:cxnSpMk id="23" creationId="{6D984E0D-A620-1786-00DD-60A05C8D38E1}"/>
          </ac:cxnSpMkLst>
        </pc:cxnChg>
        <pc:cxnChg chg="add mod">
          <ac:chgData name="Chiara Napoletano" userId="3382be66-87d3-4f88-8936-a80a8def1550" providerId="ADAL" clId="{2870EBE4-5F25-2D45-8E98-26E458B7926F}" dt="2025-02-26T11:41:10.341" v="160" actId="1037"/>
          <ac:cxnSpMkLst>
            <pc:docMk/>
            <pc:sldMk cId="21570610" sldId="256"/>
            <ac:cxnSpMk id="25" creationId="{281F71A7-CE9D-7B63-1E7C-61CAA1C3E294}"/>
          </ac:cxnSpMkLst>
        </pc:cxnChg>
        <pc:cxnChg chg="add mod">
          <ac:chgData name="Chiara Napoletano" userId="3382be66-87d3-4f88-8936-a80a8def1550" providerId="ADAL" clId="{2870EBE4-5F25-2D45-8E98-26E458B7926F}" dt="2025-02-26T11:42:13.704" v="227" actId="13822"/>
          <ac:cxnSpMkLst>
            <pc:docMk/>
            <pc:sldMk cId="21570610" sldId="256"/>
            <ac:cxnSpMk id="29" creationId="{3B8DD418-BB58-C938-D70A-E7E735647765}"/>
          </ac:cxnSpMkLst>
        </pc:cxnChg>
        <pc:cxnChg chg="add mod">
          <ac:chgData name="Chiara Napoletano" userId="3382be66-87d3-4f88-8936-a80a8def1550" providerId="ADAL" clId="{2870EBE4-5F25-2D45-8E98-26E458B7926F}" dt="2025-02-26T11:42:24.857" v="268" actId="1036"/>
          <ac:cxnSpMkLst>
            <pc:docMk/>
            <pc:sldMk cId="21570610" sldId="256"/>
            <ac:cxnSpMk id="30" creationId="{657DBAFB-775A-4778-6D9D-AE61C2F414B9}"/>
          </ac:cxnSpMkLst>
        </pc:cxnChg>
      </pc:sldChg>
      <pc:sldChg chg="delSp del mod">
        <pc:chgData name="Chiara Napoletano" userId="3382be66-87d3-4f88-8936-a80a8def1550" providerId="ADAL" clId="{2870EBE4-5F25-2D45-8E98-26E458B7926F}" dt="2025-02-26T11:33:52.927" v="1" actId="2696"/>
        <pc:sldMkLst>
          <pc:docMk/>
          <pc:sldMk cId="828757656" sldId="257"/>
        </pc:sldMkLst>
      </pc:sldChg>
      <pc:sldChg chg="addSp delSp modSp new mod ord">
        <pc:chgData name="Chiara Napoletano" userId="3382be66-87d3-4f88-8936-a80a8def1550" providerId="ADAL" clId="{2870EBE4-5F25-2D45-8E98-26E458B7926F}" dt="2025-03-07T10:42:54.275" v="2458" actId="20577"/>
        <pc:sldMkLst>
          <pc:docMk/>
          <pc:sldMk cId="1017312502" sldId="257"/>
        </pc:sldMkLst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6" creationId="{C980446E-4BA0-2070-5D39-25AB364D877A}"/>
          </ac:spMkLst>
        </pc:spChg>
        <pc:spChg chg="add mod">
          <ac:chgData name="Chiara Napoletano" userId="3382be66-87d3-4f88-8936-a80a8def1550" providerId="ADAL" clId="{2870EBE4-5F25-2D45-8E98-26E458B7926F}" dt="2025-02-26T12:27:07.826" v="1376" actId="20577"/>
          <ac:spMkLst>
            <pc:docMk/>
            <pc:sldMk cId="1017312502" sldId="257"/>
            <ac:spMk id="7" creationId="{04D09E58-5328-A6E1-9060-B141ABD653C8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13" creationId="{EE9C2104-6E01-CB08-2908-D3C80E1D91DE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14" creationId="{D727FB3C-AFE4-46CF-5832-477A02762E47}"/>
          </ac:spMkLst>
        </pc:spChg>
        <pc:spChg chg="add mod">
          <ac:chgData name="Chiara Napoletano" userId="3382be66-87d3-4f88-8936-a80a8def1550" providerId="ADAL" clId="{2870EBE4-5F25-2D45-8E98-26E458B7926F}" dt="2025-02-26T12:23:13.516" v="1275" actId="1076"/>
          <ac:spMkLst>
            <pc:docMk/>
            <pc:sldMk cId="1017312502" sldId="257"/>
            <ac:spMk id="15" creationId="{421F5447-83B2-F6DD-3A14-DFFDDD5CDA41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16" creationId="{6F4B7E3E-5BD3-854B-FDCC-17F3E63D736B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17" creationId="{61A559D9-BCE0-2013-F63B-F9CCF508DC4E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18" creationId="{12B2D6A9-ABFC-9891-D7DB-205D40D1BBEA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19" creationId="{5BD51D78-308F-EC38-841E-2D948D771348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20" creationId="{8BACE24F-FF33-AB7F-1C77-6CC1A2DF341F}"/>
          </ac:spMkLst>
        </pc:spChg>
        <pc:spChg chg="add mod">
          <ac:chgData name="Chiara Napoletano" userId="3382be66-87d3-4f88-8936-a80a8def1550" providerId="ADAL" clId="{2870EBE4-5F25-2D45-8E98-26E458B7926F}" dt="2025-02-26T12:23:33.484" v="1281" actId="1076"/>
          <ac:spMkLst>
            <pc:docMk/>
            <pc:sldMk cId="1017312502" sldId="257"/>
            <ac:spMk id="21" creationId="{F2D68986-6716-4182-F441-A0D5420C1090}"/>
          </ac:spMkLst>
        </pc:spChg>
        <pc:spChg chg="add mod">
          <ac:chgData name="Chiara Napoletano" userId="3382be66-87d3-4f88-8936-a80a8def1550" providerId="ADAL" clId="{2870EBE4-5F25-2D45-8E98-26E458B7926F}" dt="2025-02-26T12:26:06.101" v="1298" actId="164"/>
          <ac:spMkLst>
            <pc:docMk/>
            <pc:sldMk cId="1017312502" sldId="257"/>
            <ac:spMk id="22" creationId="{615202C3-5D72-F64B-1A59-F731DBFE14C3}"/>
          </ac:spMkLst>
        </pc:spChg>
        <pc:spChg chg="add mod">
          <ac:chgData name="Chiara Napoletano" userId="3382be66-87d3-4f88-8936-a80a8def1550" providerId="ADAL" clId="{2870EBE4-5F25-2D45-8E98-26E458B7926F}" dt="2025-02-26T12:22:56.184" v="1272" actId="20577"/>
          <ac:spMkLst>
            <pc:docMk/>
            <pc:sldMk cId="1017312502" sldId="257"/>
            <ac:spMk id="25" creationId="{F68727F7-832E-3027-B17D-476752FD8298}"/>
          </ac:spMkLst>
        </pc:spChg>
        <pc:spChg chg="add mod">
          <ac:chgData name="Chiara Napoletano" userId="3382be66-87d3-4f88-8936-a80a8def1550" providerId="ADAL" clId="{2870EBE4-5F25-2D45-8E98-26E458B7926F}" dt="2025-03-07T10:42:54.275" v="2458" actId="20577"/>
          <ac:spMkLst>
            <pc:docMk/>
            <pc:sldMk cId="1017312502" sldId="257"/>
            <ac:spMk id="51" creationId="{C53404BC-C6E7-3671-C725-CB8E48CA9445}"/>
          </ac:spMkLst>
        </pc:spChg>
        <pc:cxnChg chg="add">
          <ac:chgData name="Chiara Napoletano" userId="3382be66-87d3-4f88-8936-a80a8def1550" providerId="ADAL" clId="{2870EBE4-5F25-2D45-8E98-26E458B7926F}" dt="2025-02-26T12:22:22.935" v="1253" actId="11529"/>
          <ac:cxnSpMkLst>
            <pc:docMk/>
            <pc:sldMk cId="1017312502" sldId="257"/>
            <ac:cxnSpMk id="24" creationId="{66261418-68F1-FA8D-51B8-828BFEAA98BA}"/>
          </ac:cxnSpMkLst>
        </pc:cxnChg>
        <pc:cxnChg chg="add">
          <ac:chgData name="Chiara Napoletano" userId="3382be66-87d3-4f88-8936-a80a8def1550" providerId="ADAL" clId="{2870EBE4-5F25-2D45-8E98-26E458B7926F}" dt="2025-02-26T12:23:58.237" v="1283" actId="11529"/>
          <ac:cxnSpMkLst>
            <pc:docMk/>
            <pc:sldMk cId="1017312502" sldId="257"/>
            <ac:cxnSpMk id="27" creationId="{9F2B719C-B20A-2F25-42EB-CC9844AC681C}"/>
          </ac:cxnSpMkLst>
        </pc:cxnChg>
        <pc:cxnChg chg="add">
          <ac:chgData name="Chiara Napoletano" userId="3382be66-87d3-4f88-8936-a80a8def1550" providerId="ADAL" clId="{2870EBE4-5F25-2D45-8E98-26E458B7926F}" dt="2025-02-26T12:24:15.327" v="1284" actId="11529"/>
          <ac:cxnSpMkLst>
            <pc:docMk/>
            <pc:sldMk cId="1017312502" sldId="257"/>
            <ac:cxnSpMk id="29" creationId="{80A9FDF9-CD0A-9477-61A1-4A879AAE6FFA}"/>
          </ac:cxnSpMkLst>
        </pc:cxnChg>
        <pc:cxnChg chg="add mod">
          <ac:chgData name="Chiara Napoletano" userId="3382be66-87d3-4f88-8936-a80a8def1550" providerId="ADAL" clId="{2870EBE4-5F25-2D45-8E98-26E458B7926F}" dt="2025-02-26T12:25:07.237" v="1292" actId="14100"/>
          <ac:cxnSpMkLst>
            <pc:docMk/>
            <pc:sldMk cId="1017312502" sldId="257"/>
            <ac:cxnSpMk id="31" creationId="{45615A2A-6662-5820-FDBF-D9350BB52383}"/>
          </ac:cxnSpMkLst>
        </pc:cxnChg>
        <pc:cxnChg chg="add">
          <ac:chgData name="Chiara Napoletano" userId="3382be66-87d3-4f88-8936-a80a8def1550" providerId="ADAL" clId="{2870EBE4-5F25-2D45-8E98-26E458B7926F}" dt="2025-02-26T12:24:41.156" v="1288" actId="11529"/>
          <ac:cxnSpMkLst>
            <pc:docMk/>
            <pc:sldMk cId="1017312502" sldId="257"/>
            <ac:cxnSpMk id="33" creationId="{5008C9A9-AD51-E748-1FC2-E5501A3C64A8}"/>
          </ac:cxnSpMkLst>
        </pc:cxnChg>
        <pc:cxnChg chg="add mod">
          <ac:chgData name="Chiara Napoletano" userId="3382be66-87d3-4f88-8936-a80a8def1550" providerId="ADAL" clId="{2870EBE4-5F25-2D45-8E98-26E458B7926F}" dt="2025-02-26T12:24:54.870" v="1290" actId="14100"/>
          <ac:cxnSpMkLst>
            <pc:docMk/>
            <pc:sldMk cId="1017312502" sldId="257"/>
            <ac:cxnSpMk id="35" creationId="{492BD6DD-66DA-D0C8-F55E-27FCA79A8C96}"/>
          </ac:cxnSpMkLst>
        </pc:cxnChg>
        <pc:cxnChg chg="add">
          <ac:chgData name="Chiara Napoletano" userId="3382be66-87d3-4f88-8936-a80a8def1550" providerId="ADAL" clId="{2870EBE4-5F25-2D45-8E98-26E458B7926F}" dt="2025-02-26T12:25:01.425" v="1291" actId="11529"/>
          <ac:cxnSpMkLst>
            <pc:docMk/>
            <pc:sldMk cId="1017312502" sldId="257"/>
            <ac:cxnSpMk id="38" creationId="{5E1D7A56-F90C-4724-B6B0-E110E61E3D1C}"/>
          </ac:cxnSpMkLst>
        </pc:cxnChg>
        <pc:cxnChg chg="add">
          <ac:chgData name="Chiara Napoletano" userId="3382be66-87d3-4f88-8936-a80a8def1550" providerId="ADAL" clId="{2870EBE4-5F25-2D45-8E98-26E458B7926F}" dt="2025-02-26T12:25:20.887" v="1293" actId="11529"/>
          <ac:cxnSpMkLst>
            <pc:docMk/>
            <pc:sldMk cId="1017312502" sldId="257"/>
            <ac:cxnSpMk id="41" creationId="{7C90AF71-5DCC-4DAC-6C54-EDA0B44ABBF8}"/>
          </ac:cxnSpMkLst>
        </pc:cxnChg>
        <pc:cxnChg chg="add">
          <ac:chgData name="Chiara Napoletano" userId="3382be66-87d3-4f88-8936-a80a8def1550" providerId="ADAL" clId="{2870EBE4-5F25-2D45-8E98-26E458B7926F}" dt="2025-02-26T12:25:27.691" v="1294" actId="11529"/>
          <ac:cxnSpMkLst>
            <pc:docMk/>
            <pc:sldMk cId="1017312502" sldId="257"/>
            <ac:cxnSpMk id="43" creationId="{AB34BAD1-4E07-4067-F979-5044F67C30F1}"/>
          </ac:cxnSpMkLst>
        </pc:cxnChg>
        <pc:cxnChg chg="add">
          <ac:chgData name="Chiara Napoletano" userId="3382be66-87d3-4f88-8936-a80a8def1550" providerId="ADAL" clId="{2870EBE4-5F25-2D45-8E98-26E458B7926F}" dt="2025-02-26T12:25:32.708" v="1295" actId="11529"/>
          <ac:cxnSpMkLst>
            <pc:docMk/>
            <pc:sldMk cId="1017312502" sldId="257"/>
            <ac:cxnSpMk id="45" creationId="{A4155846-3837-0E3A-78A6-5FFF555CC78A}"/>
          </ac:cxnSpMkLst>
        </pc:cxnChg>
        <pc:cxnChg chg="add">
          <ac:chgData name="Chiara Napoletano" userId="3382be66-87d3-4f88-8936-a80a8def1550" providerId="ADAL" clId="{2870EBE4-5F25-2D45-8E98-26E458B7926F}" dt="2025-02-26T12:25:39.324" v="1296" actId="11529"/>
          <ac:cxnSpMkLst>
            <pc:docMk/>
            <pc:sldMk cId="1017312502" sldId="257"/>
            <ac:cxnSpMk id="47" creationId="{A730443F-B138-0A3D-8CB4-AE26F6FD2DC5}"/>
          </ac:cxnSpMkLst>
        </pc:cxnChg>
        <pc:cxnChg chg="add">
          <ac:chgData name="Chiara Napoletano" userId="3382be66-87d3-4f88-8936-a80a8def1550" providerId="ADAL" clId="{2870EBE4-5F25-2D45-8E98-26E458B7926F}" dt="2025-02-26T12:25:45.340" v="1297" actId="11529"/>
          <ac:cxnSpMkLst>
            <pc:docMk/>
            <pc:sldMk cId="1017312502" sldId="257"/>
            <ac:cxnSpMk id="49" creationId="{23F3B8DC-6F3E-45CF-B249-BC16CCD1D9A2}"/>
          </ac:cxnSpMkLst>
        </pc:cxnChg>
      </pc:sldChg>
      <pc:sldChg chg="new del">
        <pc:chgData name="Chiara Napoletano" userId="3382be66-87d3-4f88-8936-a80a8def1550" providerId="ADAL" clId="{2870EBE4-5F25-2D45-8E98-26E458B7926F}" dt="2025-02-27T09:57:48.283" v="1540" actId="2696"/>
        <pc:sldMkLst>
          <pc:docMk/>
          <pc:sldMk cId="128233092" sldId="258"/>
        </pc:sldMkLst>
      </pc:sldChg>
      <pc:sldChg chg="addSp delSp modSp new mod ord">
        <pc:chgData name="Chiara Napoletano" userId="3382be66-87d3-4f88-8936-a80a8def1550" providerId="ADAL" clId="{2870EBE4-5F25-2D45-8E98-26E458B7926F}" dt="2025-03-07T09:24:44.780" v="2457" actId="20577"/>
        <pc:sldMkLst>
          <pc:docMk/>
          <pc:sldMk cId="3308176400" sldId="258"/>
        </pc:sldMkLst>
        <pc:spChg chg="add mod">
          <ac:chgData name="Chiara Napoletano" userId="3382be66-87d3-4f88-8936-a80a8def1550" providerId="ADAL" clId="{2870EBE4-5F25-2D45-8E98-26E458B7926F}" dt="2025-03-07T09:24:44.780" v="2457" actId="20577"/>
          <ac:spMkLst>
            <pc:docMk/>
            <pc:sldMk cId="3308176400" sldId="258"/>
            <ac:spMk id="8" creationId="{E9DA10E6-2039-7BFB-AC84-983D9C249682}"/>
          </ac:spMkLst>
        </pc:spChg>
        <pc:picChg chg="add mod">
          <ac:chgData name="Chiara Napoletano" userId="3382be66-87d3-4f88-8936-a80a8def1550" providerId="ADAL" clId="{2870EBE4-5F25-2D45-8E98-26E458B7926F}" dt="2025-02-28T18:29:34.376" v="2452" actId="1076"/>
          <ac:picMkLst>
            <pc:docMk/>
            <pc:sldMk cId="3308176400" sldId="258"/>
            <ac:picMk id="5" creationId="{AAEFA446-162D-97A5-4787-0C066D1D5663}"/>
          </ac:picMkLst>
        </pc:picChg>
        <pc:picChg chg="add mod">
          <ac:chgData name="Chiara Napoletano" userId="3382be66-87d3-4f88-8936-a80a8def1550" providerId="ADAL" clId="{2870EBE4-5F25-2D45-8E98-26E458B7926F}" dt="2025-02-28T18:29:34.376" v="2452" actId="1076"/>
          <ac:picMkLst>
            <pc:docMk/>
            <pc:sldMk cId="3308176400" sldId="258"/>
            <ac:picMk id="7" creationId="{2C31801D-7B6C-DBE6-ABA1-448470CBB813}"/>
          </ac:picMkLst>
        </pc:picChg>
      </pc:sldChg>
      <pc:sldChg chg="addSp delSp modSp new mod">
        <pc:chgData name="Chiara Napoletano" userId="3382be66-87d3-4f88-8936-a80a8def1550" providerId="ADAL" clId="{2870EBE4-5F25-2D45-8E98-26E458B7926F}" dt="2025-03-07T11:15:57.206" v="2463" actId="478"/>
        <pc:sldMkLst>
          <pc:docMk/>
          <pc:sldMk cId="2355902487" sldId="259"/>
        </pc:sldMkLst>
        <pc:spChg chg="add del">
          <ac:chgData name="Chiara Napoletano" userId="3382be66-87d3-4f88-8936-a80a8def1550" providerId="ADAL" clId="{2870EBE4-5F25-2D45-8E98-26E458B7926F}" dt="2025-03-07T11:15:57.206" v="2463" actId="478"/>
          <ac:spMkLst>
            <pc:docMk/>
            <pc:sldMk cId="2355902487" sldId="259"/>
            <ac:spMk id="4" creationId="{F989B469-2506-AAAE-01E1-DD634275D4F6}"/>
          </ac:spMkLst>
        </pc:spChg>
        <pc:graphicFrameChg chg="add mod">
          <ac:chgData name="Chiara Napoletano" userId="3382be66-87d3-4f88-8936-a80a8def1550" providerId="ADAL" clId="{2870EBE4-5F25-2D45-8E98-26E458B7926F}" dt="2025-02-27T11:50:15.544" v="1893" actId="1076"/>
          <ac:graphicFrameMkLst>
            <pc:docMk/>
            <pc:sldMk cId="2355902487" sldId="259"/>
            <ac:graphicFrameMk id="5" creationId="{15767E06-43C2-1974-7FF8-6BA689706DB7}"/>
          </ac:graphicFrameMkLst>
        </pc:graphicFrameChg>
        <pc:graphicFrameChg chg="add mod">
          <ac:chgData name="Chiara Napoletano" userId="3382be66-87d3-4f88-8936-a80a8def1550" providerId="ADAL" clId="{2870EBE4-5F25-2D45-8E98-26E458B7926F}" dt="2025-02-27T11:51:03.568" v="1901" actId="1076"/>
          <ac:graphicFrameMkLst>
            <pc:docMk/>
            <pc:sldMk cId="2355902487" sldId="259"/>
            <ac:graphicFrameMk id="8" creationId="{9EA325EE-CC11-1DCE-8321-2B126458FB7B}"/>
          </ac:graphicFrameMkLst>
        </pc:graphicFrameChg>
        <pc:graphicFrameChg chg="add mod">
          <ac:chgData name="Chiara Napoletano" userId="3382be66-87d3-4f88-8936-a80a8def1550" providerId="ADAL" clId="{2870EBE4-5F25-2D45-8E98-26E458B7926F}" dt="2025-03-07T10:44:26.692" v="2461"/>
          <ac:graphicFrameMkLst>
            <pc:docMk/>
            <pc:sldMk cId="2355902487" sldId="259"/>
            <ac:graphicFrameMk id="9" creationId="{0B886F9C-51EA-8175-CAC0-D2A32BFB7E94}"/>
          </ac:graphicFrameMkLst>
        </pc:graphicFrameChg>
        <pc:picChg chg="add mod">
          <ac:chgData name="Chiara Napoletano" userId="3382be66-87d3-4f88-8936-a80a8def1550" providerId="ADAL" clId="{2870EBE4-5F25-2D45-8E98-26E458B7926F}" dt="2025-02-27T12:45:46.233" v="2221" actId="1076"/>
          <ac:picMkLst>
            <pc:docMk/>
            <pc:sldMk cId="2355902487" sldId="259"/>
            <ac:picMk id="3" creationId="{1D79F898-C3AC-114B-9FD4-9EA648410E7F}"/>
          </ac:picMkLst>
        </pc:picChg>
      </pc:sldChg>
      <pc:sldChg chg="addSp delSp modSp new mod">
        <pc:chgData name="Chiara Napoletano" userId="3382be66-87d3-4f88-8936-a80a8def1550" providerId="ADAL" clId="{2870EBE4-5F25-2D45-8E98-26E458B7926F}" dt="2025-02-27T12:33:23.645" v="2057" actId="1076"/>
        <pc:sldMkLst>
          <pc:docMk/>
          <pc:sldMk cId="3523015048" sldId="260"/>
        </pc:sldMkLst>
        <pc:picChg chg="add mod">
          <ac:chgData name="Chiara Napoletano" userId="3382be66-87d3-4f88-8936-a80a8def1550" providerId="ADAL" clId="{2870EBE4-5F25-2D45-8E98-26E458B7926F}" dt="2025-02-27T12:09:42.700" v="2048" actId="1036"/>
          <ac:picMkLst>
            <pc:docMk/>
            <pc:sldMk cId="3523015048" sldId="260"/>
            <ac:picMk id="5" creationId="{0C4FB404-5E87-36B8-CC5D-92B48C1EE886}"/>
          </ac:picMkLst>
        </pc:picChg>
        <pc:picChg chg="add mod">
          <ac:chgData name="Chiara Napoletano" userId="3382be66-87d3-4f88-8936-a80a8def1550" providerId="ADAL" clId="{2870EBE4-5F25-2D45-8E98-26E458B7926F}" dt="2025-02-27T12:33:23.645" v="2057" actId="1076"/>
          <ac:picMkLst>
            <pc:docMk/>
            <pc:sldMk cId="3523015048" sldId="260"/>
            <ac:picMk id="9" creationId="{7DE6B8E6-B74A-BCEE-E709-6F60E829A6C9}"/>
          </ac:picMkLst>
        </pc:picChg>
      </pc:sldChg>
      <pc:sldChg chg="addSp delSp modSp new mod">
        <pc:chgData name="Chiara Napoletano" userId="3382be66-87d3-4f88-8936-a80a8def1550" providerId="ADAL" clId="{2870EBE4-5F25-2D45-8E98-26E458B7926F}" dt="2025-02-27T12:35:41.244" v="2098" actId="1035"/>
        <pc:sldMkLst>
          <pc:docMk/>
          <pc:sldMk cId="1291988865" sldId="261"/>
        </pc:sldMkLst>
        <pc:picChg chg="add mod">
          <ac:chgData name="Chiara Napoletano" userId="3382be66-87d3-4f88-8936-a80a8def1550" providerId="ADAL" clId="{2870EBE4-5F25-2D45-8E98-26E458B7926F}" dt="2025-02-27T12:34:55.383" v="2060"/>
          <ac:picMkLst>
            <pc:docMk/>
            <pc:sldMk cId="1291988865" sldId="261"/>
            <ac:picMk id="5" creationId="{2A5065CC-51FB-886B-0B8B-D63554751EED}"/>
          </ac:picMkLst>
        </pc:picChg>
        <pc:picChg chg="add mod">
          <ac:chgData name="Chiara Napoletano" userId="3382be66-87d3-4f88-8936-a80a8def1550" providerId="ADAL" clId="{2870EBE4-5F25-2D45-8E98-26E458B7926F}" dt="2025-02-27T12:35:41.244" v="2098" actId="1035"/>
          <ac:picMkLst>
            <pc:docMk/>
            <pc:sldMk cId="1291988865" sldId="261"/>
            <ac:picMk id="6" creationId="{39F52128-45E3-88CF-1AA4-325539276D85}"/>
          </ac:picMkLst>
        </pc:picChg>
      </pc:sldChg>
      <pc:sldChg chg="addSp delSp modSp new mod">
        <pc:chgData name="Chiara Napoletano" userId="3382be66-87d3-4f88-8936-a80a8def1550" providerId="ADAL" clId="{2870EBE4-5F25-2D45-8E98-26E458B7926F}" dt="2025-02-27T12:38:14.740" v="2137" actId="1036"/>
        <pc:sldMkLst>
          <pc:docMk/>
          <pc:sldMk cId="1759151178" sldId="262"/>
        </pc:sldMkLst>
        <pc:picChg chg="add mod">
          <ac:chgData name="Chiara Napoletano" userId="3382be66-87d3-4f88-8936-a80a8def1550" providerId="ADAL" clId="{2870EBE4-5F25-2D45-8E98-26E458B7926F}" dt="2025-02-27T12:37:47.338" v="2102"/>
          <ac:picMkLst>
            <pc:docMk/>
            <pc:sldMk cId="1759151178" sldId="262"/>
            <ac:picMk id="4" creationId="{B038A6AD-5FFD-9A96-BDA3-BCFCC12445A7}"/>
          </ac:picMkLst>
        </pc:picChg>
        <pc:picChg chg="add mod">
          <ac:chgData name="Chiara Napoletano" userId="3382be66-87d3-4f88-8936-a80a8def1550" providerId="ADAL" clId="{2870EBE4-5F25-2D45-8E98-26E458B7926F}" dt="2025-02-27T12:38:14.740" v="2137" actId="1036"/>
          <ac:picMkLst>
            <pc:docMk/>
            <pc:sldMk cId="1759151178" sldId="262"/>
            <ac:picMk id="5" creationId="{23E3C749-23FC-5D49-BC20-8F7A347EF71B}"/>
          </ac:picMkLst>
        </pc:picChg>
      </pc:sldChg>
      <pc:sldChg chg="addSp delSp modSp new mod">
        <pc:chgData name="Chiara Napoletano" userId="3382be66-87d3-4f88-8936-a80a8def1550" providerId="ADAL" clId="{2870EBE4-5F25-2D45-8E98-26E458B7926F}" dt="2025-02-27T12:45:19.736" v="2218" actId="1036"/>
        <pc:sldMkLst>
          <pc:docMk/>
          <pc:sldMk cId="1242771309" sldId="263"/>
        </pc:sldMkLst>
        <pc:picChg chg="add mod">
          <ac:chgData name="Chiara Napoletano" userId="3382be66-87d3-4f88-8936-a80a8def1550" providerId="ADAL" clId="{2870EBE4-5F25-2D45-8E98-26E458B7926F}" dt="2025-02-27T12:40:09.300" v="2145" actId="1076"/>
          <ac:picMkLst>
            <pc:docMk/>
            <pc:sldMk cId="1242771309" sldId="263"/>
            <ac:picMk id="5" creationId="{D1919BFD-D4E8-2823-A7B9-7F4C98AAB4F4}"/>
          </ac:picMkLst>
        </pc:picChg>
        <pc:picChg chg="add mod">
          <ac:chgData name="Chiara Napoletano" userId="3382be66-87d3-4f88-8936-a80a8def1550" providerId="ADAL" clId="{2870EBE4-5F25-2D45-8E98-26E458B7926F}" dt="2025-02-27T12:45:19.736" v="2218" actId="1036"/>
          <ac:picMkLst>
            <pc:docMk/>
            <pc:sldMk cId="1242771309" sldId="263"/>
            <ac:picMk id="6" creationId="{AEE623DB-1567-D356-5003-3F3F92CB1103}"/>
          </ac:picMkLst>
        </pc:picChg>
      </pc:sldChg>
      <pc:sldChg chg="addSp delSp modSp new mod">
        <pc:chgData name="Chiara Napoletano" userId="3382be66-87d3-4f88-8936-a80a8def1550" providerId="ADAL" clId="{2870EBE4-5F25-2D45-8E98-26E458B7926F}" dt="2025-02-27T12:42:56.347" v="2189" actId="1036"/>
        <pc:sldMkLst>
          <pc:docMk/>
          <pc:sldMk cId="332965296" sldId="264"/>
        </pc:sldMkLst>
        <pc:picChg chg="add mod">
          <ac:chgData name="Chiara Napoletano" userId="3382be66-87d3-4f88-8936-a80a8def1550" providerId="ADAL" clId="{2870EBE4-5F25-2D45-8E98-26E458B7926F}" dt="2025-02-27T12:42:28.530" v="2174" actId="1076"/>
          <ac:picMkLst>
            <pc:docMk/>
            <pc:sldMk cId="332965296" sldId="264"/>
            <ac:picMk id="5" creationId="{41DAC9AA-7FB9-3F7D-0173-F82F109084A2}"/>
          </ac:picMkLst>
        </pc:picChg>
        <pc:picChg chg="add mod">
          <ac:chgData name="Chiara Napoletano" userId="3382be66-87d3-4f88-8936-a80a8def1550" providerId="ADAL" clId="{2870EBE4-5F25-2D45-8E98-26E458B7926F}" dt="2025-02-27T12:42:56.347" v="2189" actId="1036"/>
          <ac:picMkLst>
            <pc:docMk/>
            <pc:sldMk cId="332965296" sldId="264"/>
            <ac:picMk id="6" creationId="{10565D35-F579-A063-1BD8-45DF5C68F9B1}"/>
          </ac:picMkLst>
        </pc:picChg>
      </pc:sldChg>
      <pc:sldChg chg="addSp delSp modSp new mod setBg">
        <pc:chgData name="Chiara Napoletano" userId="3382be66-87d3-4f88-8936-a80a8def1550" providerId="ADAL" clId="{2870EBE4-5F25-2D45-8E98-26E458B7926F}" dt="2025-02-27T12:44:46.682" v="2207" actId="1036"/>
        <pc:sldMkLst>
          <pc:docMk/>
          <pc:sldMk cId="360458955" sldId="265"/>
        </pc:sldMkLst>
        <pc:picChg chg="add mod">
          <ac:chgData name="Chiara Napoletano" userId="3382be66-87d3-4f88-8936-a80a8def1550" providerId="ADAL" clId="{2870EBE4-5F25-2D45-8E98-26E458B7926F}" dt="2025-02-27T12:44:41.170" v="2201" actId="1076"/>
          <ac:picMkLst>
            <pc:docMk/>
            <pc:sldMk cId="360458955" sldId="265"/>
            <ac:picMk id="5" creationId="{FD643257-8C36-7214-4359-A225017EEA60}"/>
          </ac:picMkLst>
        </pc:picChg>
        <pc:picChg chg="add mod">
          <ac:chgData name="Chiara Napoletano" userId="3382be66-87d3-4f88-8936-a80a8def1550" providerId="ADAL" clId="{2870EBE4-5F25-2D45-8E98-26E458B7926F}" dt="2025-02-27T12:44:46.682" v="2207" actId="1036"/>
          <ac:picMkLst>
            <pc:docMk/>
            <pc:sldMk cId="360458955" sldId="265"/>
            <ac:picMk id="6" creationId="{328A846B-D1A5-4D7E-7A57-5B7312D13349}"/>
          </ac:picMkLst>
        </pc:picChg>
      </pc:sldChg>
      <pc:sldChg chg="addSp delSp modSp new del mod">
        <pc:chgData name="Chiara Napoletano" userId="3382be66-87d3-4f88-8936-a80a8def1550" providerId="ADAL" clId="{2870EBE4-5F25-2D45-8E98-26E458B7926F}" dt="2025-03-07T11:29:06.931" v="2525" actId="2696"/>
        <pc:sldMkLst>
          <pc:docMk/>
          <pc:sldMk cId="220382941" sldId="266"/>
        </pc:sldMkLst>
        <pc:spChg chg="del">
          <ac:chgData name="Chiara Napoletano" userId="3382be66-87d3-4f88-8936-a80a8def1550" providerId="ADAL" clId="{2870EBE4-5F25-2D45-8E98-26E458B7926F}" dt="2025-03-07T11:16:38.506" v="2465" actId="478"/>
          <ac:spMkLst>
            <pc:docMk/>
            <pc:sldMk cId="220382941" sldId="266"/>
            <ac:spMk id="2" creationId="{8D1A3EBE-C967-A811-65EC-6F3A1CBFA2A0}"/>
          </ac:spMkLst>
        </pc:spChg>
        <pc:spChg chg="del">
          <ac:chgData name="Chiara Napoletano" userId="3382be66-87d3-4f88-8936-a80a8def1550" providerId="ADAL" clId="{2870EBE4-5F25-2D45-8E98-26E458B7926F}" dt="2025-03-07T11:16:39.865" v="2466" actId="478"/>
          <ac:spMkLst>
            <pc:docMk/>
            <pc:sldMk cId="220382941" sldId="266"/>
            <ac:spMk id="3" creationId="{33DFBC62-93DD-2B26-017E-99FDAB24E388}"/>
          </ac:spMkLst>
        </pc:spChg>
        <pc:spChg chg="add del">
          <ac:chgData name="Chiara Napoletano" userId="3382be66-87d3-4f88-8936-a80a8def1550" providerId="ADAL" clId="{2870EBE4-5F25-2D45-8E98-26E458B7926F}" dt="2025-03-07T11:16:55.951" v="2468" actId="478"/>
          <ac:spMkLst>
            <pc:docMk/>
            <pc:sldMk cId="220382941" sldId="266"/>
            <ac:spMk id="5" creationId="{1210DC26-C31F-FE4E-2150-75DE2FBFDE41}"/>
          </ac:spMkLst>
        </pc:spChg>
        <pc:spChg chg="add mod">
          <ac:chgData name="Chiara Napoletano" userId="3382be66-87d3-4f88-8936-a80a8def1550" providerId="ADAL" clId="{2870EBE4-5F25-2D45-8E98-26E458B7926F}" dt="2025-03-07T11:20:01.902" v="2524" actId="164"/>
          <ac:spMkLst>
            <pc:docMk/>
            <pc:sldMk cId="220382941" sldId="266"/>
            <ac:spMk id="7" creationId="{08FC6F8D-CBD6-B164-8306-A0303DEE9100}"/>
          </ac:spMkLst>
        </pc:spChg>
        <pc:spChg chg="add mod">
          <ac:chgData name="Chiara Napoletano" userId="3382be66-87d3-4f88-8936-a80a8def1550" providerId="ADAL" clId="{2870EBE4-5F25-2D45-8E98-26E458B7926F}" dt="2025-03-07T11:20:01.902" v="2524" actId="164"/>
          <ac:spMkLst>
            <pc:docMk/>
            <pc:sldMk cId="220382941" sldId="266"/>
            <ac:spMk id="8" creationId="{CD29DE32-11FF-F62D-FC70-81F5C2187DD7}"/>
          </ac:spMkLst>
        </pc:spChg>
        <pc:spChg chg="add mod">
          <ac:chgData name="Chiara Napoletano" userId="3382be66-87d3-4f88-8936-a80a8def1550" providerId="ADAL" clId="{2870EBE4-5F25-2D45-8E98-26E458B7926F}" dt="2025-03-07T11:20:01.902" v="2524" actId="164"/>
          <ac:spMkLst>
            <pc:docMk/>
            <pc:sldMk cId="220382941" sldId="266"/>
            <ac:spMk id="9" creationId="{FA1FAD9E-8E22-F6B7-73D0-409DC0AFEA5A}"/>
          </ac:spMkLst>
        </pc:spChg>
        <pc:spChg chg="add mod">
          <ac:chgData name="Chiara Napoletano" userId="3382be66-87d3-4f88-8936-a80a8def1550" providerId="ADAL" clId="{2870EBE4-5F25-2D45-8E98-26E458B7926F}" dt="2025-03-07T11:20:01.902" v="2524" actId="164"/>
          <ac:spMkLst>
            <pc:docMk/>
            <pc:sldMk cId="220382941" sldId="266"/>
            <ac:spMk id="10" creationId="{8C9B2A53-37A4-997D-79D4-AF489468724F}"/>
          </ac:spMkLst>
        </pc:spChg>
        <pc:grpChg chg="add mod">
          <ac:chgData name="Chiara Napoletano" userId="3382be66-87d3-4f88-8936-a80a8def1550" providerId="ADAL" clId="{2870EBE4-5F25-2D45-8E98-26E458B7926F}" dt="2025-03-07T11:20:01.902" v="2524" actId="164"/>
          <ac:grpSpMkLst>
            <pc:docMk/>
            <pc:sldMk cId="220382941" sldId="266"/>
            <ac:grpSpMk id="11" creationId="{0EC6D5FE-B71F-C40B-E874-3D3A13BECD3B}"/>
          </ac:grpSpMkLst>
        </pc:grpChg>
        <pc:picChg chg="add mod">
          <ac:chgData name="Chiara Napoletano" userId="3382be66-87d3-4f88-8936-a80a8def1550" providerId="ADAL" clId="{2870EBE4-5F25-2D45-8E98-26E458B7926F}" dt="2025-03-07T11:20:01.902" v="2524" actId="164"/>
          <ac:picMkLst>
            <pc:docMk/>
            <pc:sldMk cId="220382941" sldId="266"/>
            <ac:picMk id="6" creationId="{330FD602-C15B-1DE1-D9B4-0DAA8AD9FF04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DBF22A-8F50-794A-9267-F4448D2289E2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C1F9F4-44DE-444D-880F-34961450B91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5354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1F9F4-44DE-444D-880F-34961450B91F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1271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01B27B-25BE-0A3B-7836-8E5B06D537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349B806-ED05-14B1-1188-4467DBCE0A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2ECF53E-4EF2-3403-D1A1-7D8EC0AE2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A4CC5A-C36D-F8E5-6E01-A559E8846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031F04-5963-BAA5-D31F-64FFE4A92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9442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7789499-F8A8-E41B-4E15-F90C4AD17C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9D60A82-AE50-2F2D-9DF9-ED3F3B7F28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59D6B0-9019-B97C-DBB9-F7ECA6A7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B48C146-53A2-0483-382E-6CDA15FB1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1B70F42-D7AD-DFA6-C623-B442705CF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8291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BEB9FE6-5338-534A-09B5-0787C06B8F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8D21205-0F8D-A672-ED31-BDBCADB193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B40C5E-7C27-5AD9-69D8-12AC56BDF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A3A33F6-5741-B5BF-A8D0-0F3AAB1A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C56B43C-E09E-6378-504B-C07104C44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0690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5A939D-A31F-32B9-AF03-E99C089517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F6118B7-B35F-9362-66E6-D4C712F6F1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65EAA0D-6185-91E2-AE2E-9FFDA3A46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406A4BF-7BC9-AD24-4A91-A88F69BC3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551082A-A8DF-AE79-4593-25F6F463C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2544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3B1419E-4842-3742-6EE1-9D3925213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FD96833-3A95-AEF8-07FA-BD11688E9F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0823714-DAAD-8184-052F-B5291A3DF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ACD3262-0C1B-97AC-48C7-A43BD2636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8554B42-5002-E5E7-99D5-6437D8633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4614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22F81D-CF2B-54B5-2C55-7959CF2556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4ABDED3-1494-B0A8-C8C2-DCCF924150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C26DF52-4536-C02D-FF09-099776FE1C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4CFB1D8-1DF4-A2E0-B027-4BA15424F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BDCF91C-9D04-9937-DC1D-A6C8A4499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AF0B01C-7433-BC82-1767-2D9A1DFB9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4035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04CB6F-F488-8696-500E-8E9886348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D7E864-DD1D-3EF7-ADC2-6AA074EA9F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30B60EA-0F77-A9C5-03B6-FEE40C6E30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C59CC89-C491-FCCA-AD51-16E606CD08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8E7C5E9-8A23-204F-8CE8-EDACA623B1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13F291B-AF07-9FE9-9ACD-84600F8B0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DDEEFF6-DFE2-F384-0D43-C070BECD0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E37D93C-D6A2-751D-4AF9-6576F9821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57386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A0797D-2755-1356-FFF4-B21CBC684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3098259-CE86-286A-67BC-E62454034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95FF192-F037-52A9-8783-3252960AA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8E8396D-0810-9A54-4725-77145F0D1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6205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58E828D-3786-ABBE-78B9-F980883D7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87AE1B0-4DE6-F899-EF85-D964B3855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B61FC5C-FEB1-9E38-2E0F-6AE1E7F29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3607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CC56521-0686-1289-AA82-E8DF8C71F4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D8D77EE-7769-BD20-33C6-4D3FC3326C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291800C-C09A-93B3-9BC4-FB1A59A546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DA1D2B3-4E63-229A-7C9C-CED987C27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08AE44B-AF3F-2402-2CA1-7AA2C6F54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A6C7D4D-669E-1EA2-4B5C-659CB945D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58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F7F4CF8-E5EA-11C0-6A22-DFF872865A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0AA37C7-C0A6-4A8F-E86C-E14320AC17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9660F41-42E6-72FF-DE74-9590A7050F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437597E-A1D9-F6E7-489E-FF6D32854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74209E0-8A08-6462-1EC0-CC1F2A814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DD2A3A7-86B2-2618-8ACB-163145FA2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5671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20EBBA9-92CE-CE59-508F-2B4C4D724A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EC1A68E-20BC-0714-9C4E-DAB0991131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A78F06-1035-6B52-8660-2281DA2D8C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CCED76-AE98-3045-935D-C45E8B444F66}" type="datetimeFigureOut">
              <a:rPr lang="it-IT" smtClean="0"/>
              <a:t>07/03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479D787-8DA0-8B14-B417-89E6FC5090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B0B57B-80E5-58A5-D103-975BCA584D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74A3453-3C59-AD4E-B064-6F22203BD3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2799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uppo 49">
            <a:extLst>
              <a:ext uri="{FF2B5EF4-FFF2-40B4-BE49-F238E27FC236}">
                <a16:creationId xmlns:a16="http://schemas.microsoft.com/office/drawing/2014/main" id="{CAC3DD9F-7F4E-7A09-1556-D5A08BC02BC7}"/>
              </a:ext>
            </a:extLst>
          </p:cNvPr>
          <p:cNvGrpSpPr/>
          <p:nvPr/>
        </p:nvGrpSpPr>
        <p:grpSpPr>
          <a:xfrm>
            <a:off x="747093" y="558017"/>
            <a:ext cx="9283536" cy="3240314"/>
            <a:chOff x="747093" y="558017"/>
            <a:chExt cx="9283536" cy="3240314"/>
          </a:xfrm>
        </p:grpSpPr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C980446E-4BA0-2070-5D39-25AB364D877A}"/>
                </a:ext>
              </a:extLst>
            </p:cNvPr>
            <p:cNvSpPr txBox="1"/>
            <p:nvPr/>
          </p:nvSpPr>
          <p:spPr>
            <a:xfrm>
              <a:off x="2120676" y="1493012"/>
              <a:ext cx="1703415" cy="307777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40000"/>
                      <a:lumOff val="60000"/>
                    </a:schemeClr>
                  </a:gs>
                  <a:gs pos="46000">
                    <a:schemeClr val="accent1">
                      <a:lumMod val="95000"/>
                      <a:lumOff val="5000"/>
                    </a:schemeClr>
                  </a:gs>
                  <a:gs pos="100000">
                    <a:schemeClr val="accent1">
                      <a:lumMod val="60000"/>
                    </a:schemeClr>
                  </a:gs>
                </a:gsLst>
                <a:path path="circle">
                  <a:fillToRect l="50000" t="130000" r="50000" b="-30000"/>
                </a:path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400" dirty="0" err="1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Criteria</a:t>
              </a:r>
              <a:r>
                <a:rPr lang="it-IT" sz="1400" dirty="0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 of </a:t>
              </a:r>
              <a:r>
                <a:rPr lang="it-IT" sz="1400" dirty="0" err="1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inclusion</a:t>
              </a:r>
              <a:endParaRPr lang="it-IT" sz="1400" dirty="0">
                <a:solidFill>
                  <a:schemeClr val="tx2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04D09E58-5328-A6E1-9060-B141ABD653C8}"/>
                </a:ext>
              </a:extLst>
            </p:cNvPr>
            <p:cNvSpPr txBox="1"/>
            <p:nvPr/>
          </p:nvSpPr>
          <p:spPr>
            <a:xfrm>
              <a:off x="6672081" y="1493012"/>
              <a:ext cx="1729897" cy="307777"/>
            </a:xfrm>
            <a:prstGeom prst="rect">
              <a:avLst/>
            </a:prstGeom>
            <a:ln w="12700" cap="flat"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400" dirty="0" err="1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Criteria</a:t>
              </a:r>
              <a:r>
                <a:rPr lang="it-IT" sz="1400" dirty="0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 of </a:t>
              </a:r>
              <a:r>
                <a:rPr lang="it-IT" sz="1400" dirty="0" err="1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exclusion</a:t>
              </a:r>
              <a:endParaRPr lang="it-IT" sz="1400" dirty="0">
                <a:solidFill>
                  <a:schemeClr val="tx2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EE9C2104-6E01-CB08-2908-D3C80E1D91DE}"/>
                </a:ext>
              </a:extLst>
            </p:cNvPr>
            <p:cNvSpPr txBox="1"/>
            <p:nvPr/>
          </p:nvSpPr>
          <p:spPr>
            <a:xfrm>
              <a:off x="747093" y="1942658"/>
              <a:ext cx="763351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i="1" dirty="0" err="1">
                  <a:solidFill>
                    <a:schemeClr val="tx1"/>
                  </a:solidFill>
                </a:rPr>
                <a:t>wt</a:t>
              </a:r>
              <a:r>
                <a:rPr lang="it-IT" sz="1000" dirty="0">
                  <a:solidFill>
                    <a:schemeClr val="tx1"/>
                  </a:solidFill>
                </a:rPr>
                <a:t>-NSCLC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D727FB3C-AFE4-46CF-5832-477A02762E47}"/>
                </a:ext>
              </a:extLst>
            </p:cNvPr>
            <p:cNvSpPr txBox="1"/>
            <p:nvPr/>
          </p:nvSpPr>
          <p:spPr>
            <a:xfrm>
              <a:off x="1336328" y="2359404"/>
              <a:ext cx="896399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>
                  <a:solidFill>
                    <a:schemeClr val="tx1"/>
                  </a:solidFill>
                </a:rPr>
                <a:t>Age&gt;18years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421F5447-83B2-F6DD-3A14-DFFDDD5CDA41}"/>
                </a:ext>
              </a:extLst>
            </p:cNvPr>
            <p:cNvSpPr txBox="1"/>
            <p:nvPr/>
          </p:nvSpPr>
          <p:spPr>
            <a:xfrm>
              <a:off x="1945629" y="2805855"/>
              <a:ext cx="574196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>
                  <a:solidFill>
                    <a:schemeClr val="tx1"/>
                  </a:solidFill>
                </a:rPr>
                <a:t>PS: 0-2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6F4B7E3E-5BD3-854B-FDCC-17F3E63D736B}"/>
                </a:ext>
              </a:extLst>
            </p:cNvPr>
            <p:cNvSpPr txBox="1"/>
            <p:nvPr/>
          </p:nvSpPr>
          <p:spPr>
            <a:xfrm>
              <a:off x="2711877" y="2936557"/>
              <a:ext cx="1261884" cy="861774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 err="1"/>
                <a:t>Stable</a:t>
              </a:r>
              <a:r>
                <a:rPr lang="it-IT" sz="1000" dirty="0"/>
                <a:t> </a:t>
              </a:r>
              <a:r>
                <a:rPr lang="it-IT" sz="1000" dirty="0" err="1"/>
                <a:t>functions</a:t>
              </a:r>
              <a:r>
                <a:rPr lang="it-IT" sz="1000" dirty="0"/>
                <a:t> of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000" dirty="0" err="1"/>
                <a:t>Liver</a:t>
              </a:r>
              <a:endParaRPr lang="it-IT" sz="1000" dirty="0"/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000" dirty="0" err="1"/>
                <a:t>Lung</a:t>
              </a:r>
              <a:endParaRPr lang="it-IT" sz="1000" dirty="0"/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000" dirty="0" err="1"/>
                <a:t>Renal</a:t>
              </a:r>
              <a:endParaRPr lang="it-IT" sz="1000" dirty="0"/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000" dirty="0"/>
                <a:t>Bone </a:t>
              </a:r>
              <a:r>
                <a:rPr lang="it-IT" sz="1000" dirty="0" err="1"/>
                <a:t>marrow</a:t>
              </a:r>
              <a:endParaRPr lang="it-IT" sz="1000" dirty="0"/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61A559D9-BCE0-2013-F63B-F9CCF508DC4E}"/>
                </a:ext>
              </a:extLst>
            </p:cNvPr>
            <p:cNvSpPr txBox="1"/>
            <p:nvPr/>
          </p:nvSpPr>
          <p:spPr>
            <a:xfrm>
              <a:off x="3489463" y="2428007"/>
              <a:ext cx="1483098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 err="1"/>
                <a:t>Stable</a:t>
              </a:r>
              <a:r>
                <a:rPr lang="it-IT" sz="1000" dirty="0"/>
                <a:t> NCS </a:t>
              </a:r>
              <a:r>
                <a:rPr lang="it-IT" sz="1000" dirty="0" err="1"/>
                <a:t>metastasis</a:t>
              </a:r>
              <a:r>
                <a:rPr lang="it-IT" sz="1000" dirty="0"/>
                <a:t> 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12B2D6A9-ABFC-9891-D7DB-205D40D1BBEA}"/>
                </a:ext>
              </a:extLst>
            </p:cNvPr>
            <p:cNvSpPr txBox="1"/>
            <p:nvPr/>
          </p:nvSpPr>
          <p:spPr>
            <a:xfrm>
              <a:off x="5388106" y="2162138"/>
              <a:ext cx="1475084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 err="1"/>
                <a:t>Previous</a:t>
              </a:r>
              <a:r>
                <a:rPr lang="it-IT" sz="1000" dirty="0"/>
                <a:t> </a:t>
              </a:r>
              <a:r>
                <a:rPr lang="it-IT" sz="1000" dirty="0" err="1"/>
                <a:t>cancer</a:t>
              </a:r>
              <a:r>
                <a:rPr lang="it-IT" sz="1000" dirty="0"/>
                <a:t> history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5BD51D78-308F-EC38-841E-2D948D771348}"/>
                </a:ext>
              </a:extLst>
            </p:cNvPr>
            <p:cNvSpPr txBox="1"/>
            <p:nvPr/>
          </p:nvSpPr>
          <p:spPr>
            <a:xfrm>
              <a:off x="6004569" y="2682744"/>
              <a:ext cx="1359668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/>
                <a:t>Autoimmune </a:t>
              </a:r>
              <a:r>
                <a:rPr lang="it-IT" sz="1000" dirty="0" err="1"/>
                <a:t>disease</a:t>
              </a:r>
              <a:endParaRPr lang="it-IT" sz="1000" dirty="0"/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8BACE24F-FF33-AB7F-1C77-6CC1A2DF341F}"/>
                </a:ext>
              </a:extLst>
            </p:cNvPr>
            <p:cNvSpPr txBox="1"/>
            <p:nvPr/>
          </p:nvSpPr>
          <p:spPr>
            <a:xfrm>
              <a:off x="6949688" y="3305889"/>
              <a:ext cx="1866217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 err="1"/>
                <a:t>Systemic</a:t>
              </a:r>
              <a:r>
                <a:rPr lang="it-IT" sz="1000" dirty="0"/>
                <a:t> </a:t>
              </a:r>
              <a:r>
                <a:rPr lang="it-IT" sz="1000" dirty="0" err="1"/>
                <a:t>immunosuppression</a:t>
              </a:r>
              <a:endParaRPr lang="it-IT" sz="1000" dirty="0"/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F2D68986-6716-4182-F441-A0D5420C1090}"/>
                </a:ext>
              </a:extLst>
            </p:cNvPr>
            <p:cNvSpPr txBox="1"/>
            <p:nvPr/>
          </p:nvSpPr>
          <p:spPr>
            <a:xfrm>
              <a:off x="8571575" y="2690336"/>
              <a:ext cx="1459054" cy="246221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 err="1"/>
                <a:t>Significant</a:t>
              </a:r>
              <a:r>
                <a:rPr lang="it-IT" sz="1000" dirty="0"/>
                <a:t> </a:t>
              </a:r>
              <a:r>
                <a:rPr lang="it-IT" sz="1000" dirty="0" err="1"/>
                <a:t>comorbidity</a:t>
              </a:r>
              <a:endParaRPr lang="it-IT" sz="1000" dirty="0"/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615202C3-5D72-F64B-1A59-F731DBFE14C3}"/>
                </a:ext>
              </a:extLst>
            </p:cNvPr>
            <p:cNvSpPr txBox="1"/>
            <p:nvPr/>
          </p:nvSpPr>
          <p:spPr>
            <a:xfrm>
              <a:off x="8571575" y="2027897"/>
              <a:ext cx="1375698" cy="400110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67000"/>
                    </a:schemeClr>
                  </a:gs>
                  <a:gs pos="48000">
                    <a:schemeClr val="accent1">
                      <a:lumMod val="97000"/>
                      <a:lumOff val="3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000" dirty="0" err="1"/>
                <a:t>Sintomatic</a:t>
              </a:r>
              <a:r>
                <a:rPr lang="it-IT" sz="1000" dirty="0"/>
                <a:t> </a:t>
              </a:r>
              <a:r>
                <a:rPr lang="it-IT" sz="1000" dirty="0" err="1"/>
                <a:t>interstitial</a:t>
              </a:r>
              <a:endParaRPr lang="it-IT" sz="1000" dirty="0"/>
            </a:p>
            <a:p>
              <a:r>
                <a:rPr lang="it-IT" sz="1000" dirty="0" err="1"/>
                <a:t>lung</a:t>
              </a:r>
              <a:r>
                <a:rPr lang="it-IT" sz="1000" dirty="0"/>
                <a:t> </a:t>
              </a:r>
              <a:r>
                <a:rPr lang="it-IT" sz="1000" dirty="0" err="1"/>
                <a:t>disease</a:t>
              </a:r>
              <a:endParaRPr lang="it-IT" sz="1000" dirty="0"/>
            </a:p>
          </p:txBody>
        </p:sp>
        <p:cxnSp>
          <p:nvCxnSpPr>
            <p:cNvPr id="24" name="Connettore 2 23">
              <a:extLst>
                <a:ext uri="{FF2B5EF4-FFF2-40B4-BE49-F238E27FC236}">
                  <a16:creationId xmlns:a16="http://schemas.microsoft.com/office/drawing/2014/main" id="{66261418-68F1-FA8D-51B8-828BFEAA98BA}"/>
                </a:ext>
              </a:extLst>
            </p:cNvPr>
            <p:cNvCxnSpPr/>
            <p:nvPr/>
          </p:nvCxnSpPr>
          <p:spPr>
            <a:xfrm>
              <a:off x="4633784" y="1646900"/>
              <a:ext cx="1285103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F68727F7-832E-3027-B17D-476752FD8298}"/>
                </a:ext>
              </a:extLst>
            </p:cNvPr>
            <p:cNvSpPr txBox="1"/>
            <p:nvPr/>
          </p:nvSpPr>
          <p:spPr>
            <a:xfrm>
              <a:off x="4453577" y="558017"/>
              <a:ext cx="1632819" cy="307777"/>
            </a:xfrm>
            <a:prstGeom prst="rect">
              <a:avLst/>
            </a:prstGeom>
            <a:ln w="12700" cap="flat">
              <a:gradFill flip="none" rotWithShape="1">
                <a:gsLst>
                  <a:gs pos="0">
                    <a:schemeClr val="accent1">
                      <a:lumMod val="40000"/>
                      <a:lumOff val="60000"/>
                    </a:schemeClr>
                  </a:gs>
                  <a:gs pos="46000">
                    <a:schemeClr val="accent1">
                      <a:lumMod val="95000"/>
                      <a:lumOff val="5000"/>
                    </a:schemeClr>
                  </a:gs>
                  <a:gs pos="100000">
                    <a:schemeClr val="accent1">
                      <a:lumMod val="60000"/>
                    </a:schemeClr>
                  </a:gs>
                </a:gsLst>
                <a:path path="circle">
                  <a:fillToRect l="50000" t="130000" r="50000" b="-30000"/>
                </a:path>
                <a:tileRect/>
              </a:gradFill>
              <a:rou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it-IT" sz="1400" dirty="0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NSCLC </a:t>
              </a:r>
              <a:r>
                <a:rPr lang="it-IT" sz="1400" dirty="0" err="1">
                  <a:solidFill>
                    <a:schemeClr val="tx2">
                      <a:lumMod val="50000"/>
                      <a:lumOff val="50000"/>
                    </a:schemeClr>
                  </a:solidFill>
                </a:rPr>
                <a:t>enrollment</a:t>
              </a:r>
              <a:endParaRPr lang="it-IT" sz="1400" dirty="0">
                <a:solidFill>
                  <a:schemeClr val="tx2">
                    <a:lumMod val="50000"/>
                    <a:lumOff val="50000"/>
                  </a:schemeClr>
                </a:solidFill>
              </a:endParaRPr>
            </a:p>
          </p:txBody>
        </p:sp>
        <p:cxnSp>
          <p:nvCxnSpPr>
            <p:cNvPr id="27" name="Connettore 2 26">
              <a:extLst>
                <a:ext uri="{FF2B5EF4-FFF2-40B4-BE49-F238E27FC236}">
                  <a16:creationId xmlns:a16="http://schemas.microsoft.com/office/drawing/2014/main" id="{9F2B719C-B20A-2F25-42EB-CC9844AC681C}"/>
                </a:ext>
              </a:extLst>
            </p:cNvPr>
            <p:cNvCxnSpPr/>
            <p:nvPr/>
          </p:nvCxnSpPr>
          <p:spPr>
            <a:xfrm>
              <a:off x="5269986" y="1013254"/>
              <a:ext cx="0" cy="47975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>
              <a:extLst>
                <a:ext uri="{FF2B5EF4-FFF2-40B4-BE49-F238E27FC236}">
                  <a16:creationId xmlns:a16="http://schemas.microsoft.com/office/drawing/2014/main" id="{80A9FDF9-CD0A-9477-61A1-4A879AAE6FFA}"/>
                </a:ext>
              </a:extLst>
            </p:cNvPr>
            <p:cNvCxnSpPr/>
            <p:nvPr/>
          </p:nvCxnSpPr>
          <p:spPr>
            <a:xfrm flipH="1">
              <a:off x="1655805" y="1800789"/>
              <a:ext cx="289824" cy="22710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>
              <a:extLst>
                <a:ext uri="{FF2B5EF4-FFF2-40B4-BE49-F238E27FC236}">
                  <a16:creationId xmlns:a16="http://schemas.microsoft.com/office/drawing/2014/main" id="{45615A2A-6662-5820-FDBF-D9350BB523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05920" y="1883566"/>
              <a:ext cx="366577" cy="40168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1 32">
              <a:extLst>
                <a:ext uri="{FF2B5EF4-FFF2-40B4-BE49-F238E27FC236}">
                  <a16:creationId xmlns:a16="http://schemas.microsoft.com/office/drawing/2014/main" id="{5008C9A9-AD51-E748-1FC2-E5501A3C64A8}"/>
                </a:ext>
              </a:extLst>
            </p:cNvPr>
            <p:cNvCxnSpPr/>
            <p:nvPr/>
          </p:nvCxnSpPr>
          <p:spPr>
            <a:xfrm flipH="1">
              <a:off x="2347784" y="1914343"/>
              <a:ext cx="238603" cy="75988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>
              <a:extLst>
                <a:ext uri="{FF2B5EF4-FFF2-40B4-BE49-F238E27FC236}">
                  <a16:creationId xmlns:a16="http://schemas.microsoft.com/office/drawing/2014/main" id="{492BD6DD-66DA-D0C8-F55E-27FCA79A8C9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81863" y="1923379"/>
              <a:ext cx="25525" cy="890067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ttore 1 37">
              <a:extLst>
                <a:ext uri="{FF2B5EF4-FFF2-40B4-BE49-F238E27FC236}">
                  <a16:creationId xmlns:a16="http://schemas.microsoft.com/office/drawing/2014/main" id="{5E1D7A56-F90C-4724-B6B0-E110E61E3D1C}"/>
                </a:ext>
              </a:extLst>
            </p:cNvPr>
            <p:cNvCxnSpPr/>
            <p:nvPr/>
          </p:nvCxnSpPr>
          <p:spPr>
            <a:xfrm>
              <a:off x="3760594" y="1883566"/>
              <a:ext cx="398647" cy="40168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ttore 1 40">
              <a:extLst>
                <a:ext uri="{FF2B5EF4-FFF2-40B4-BE49-F238E27FC236}">
                  <a16:creationId xmlns:a16="http://schemas.microsoft.com/office/drawing/2014/main" id="{7C90AF71-5DCC-4DAC-6C54-EDA0B44ABBF8}"/>
                </a:ext>
              </a:extLst>
            </p:cNvPr>
            <p:cNvCxnSpPr/>
            <p:nvPr/>
          </p:nvCxnSpPr>
          <p:spPr>
            <a:xfrm flipH="1">
              <a:off x="6376086" y="1883566"/>
              <a:ext cx="295995" cy="18220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1 42">
              <a:extLst>
                <a:ext uri="{FF2B5EF4-FFF2-40B4-BE49-F238E27FC236}">
                  <a16:creationId xmlns:a16="http://schemas.microsoft.com/office/drawing/2014/main" id="{AB34BAD1-4E07-4067-F979-5044F67C30F1}"/>
                </a:ext>
              </a:extLst>
            </p:cNvPr>
            <p:cNvCxnSpPr/>
            <p:nvPr/>
          </p:nvCxnSpPr>
          <p:spPr>
            <a:xfrm flipH="1">
              <a:off x="6998721" y="1890362"/>
              <a:ext cx="131128" cy="715263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ttore 1 44">
              <a:extLst>
                <a:ext uri="{FF2B5EF4-FFF2-40B4-BE49-F238E27FC236}">
                  <a16:creationId xmlns:a16="http://schemas.microsoft.com/office/drawing/2014/main" id="{A4155846-3837-0E3A-78A6-5FFF555CC78A}"/>
                </a:ext>
              </a:extLst>
            </p:cNvPr>
            <p:cNvCxnSpPr/>
            <p:nvPr/>
          </p:nvCxnSpPr>
          <p:spPr>
            <a:xfrm>
              <a:off x="7651818" y="1974667"/>
              <a:ext cx="0" cy="1228683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>
              <a:extLst>
                <a:ext uri="{FF2B5EF4-FFF2-40B4-BE49-F238E27FC236}">
                  <a16:creationId xmlns:a16="http://schemas.microsoft.com/office/drawing/2014/main" id="{A730443F-B138-0A3D-8CB4-AE26F6FD2DC5}"/>
                </a:ext>
              </a:extLst>
            </p:cNvPr>
            <p:cNvCxnSpPr/>
            <p:nvPr/>
          </p:nvCxnSpPr>
          <p:spPr>
            <a:xfrm>
              <a:off x="8571575" y="1800789"/>
              <a:ext cx="244330" cy="113554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1 48">
              <a:extLst>
                <a:ext uri="{FF2B5EF4-FFF2-40B4-BE49-F238E27FC236}">
                  <a16:creationId xmlns:a16="http://schemas.microsoft.com/office/drawing/2014/main" id="{23F3B8DC-6F3E-45CF-B249-BC16CCD1D9A2}"/>
                </a:ext>
              </a:extLst>
            </p:cNvPr>
            <p:cNvCxnSpPr/>
            <p:nvPr/>
          </p:nvCxnSpPr>
          <p:spPr>
            <a:xfrm>
              <a:off x="8074175" y="1942658"/>
              <a:ext cx="339793" cy="73157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C53404BC-C6E7-3671-C725-CB8E48CA9445}"/>
              </a:ext>
            </a:extLst>
          </p:cNvPr>
          <p:cNvSpPr txBox="1"/>
          <p:nvPr/>
        </p:nvSpPr>
        <p:spPr>
          <a:xfrm>
            <a:off x="2274274" y="4449642"/>
            <a:ext cx="7708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S1</a:t>
            </a:r>
            <a:r>
              <a:rPr lang="it-IT" sz="1200" dirty="0"/>
              <a:t>: </a:t>
            </a:r>
            <a:r>
              <a:rPr lang="it-IT" sz="1200" dirty="0" err="1"/>
              <a:t>Schematic</a:t>
            </a:r>
            <a:r>
              <a:rPr lang="it-IT" sz="1200" dirty="0"/>
              <a:t> </a:t>
            </a:r>
            <a:r>
              <a:rPr lang="it-IT" sz="1200" dirty="0" err="1"/>
              <a:t>representation</a:t>
            </a:r>
            <a:r>
              <a:rPr lang="it-IT" sz="1200" dirty="0"/>
              <a:t> of </a:t>
            </a:r>
            <a:r>
              <a:rPr lang="it-IT" sz="1200" dirty="0" err="1"/>
              <a:t>inclusion</a:t>
            </a:r>
            <a:r>
              <a:rPr lang="it-IT" sz="1200" dirty="0"/>
              <a:t> and </a:t>
            </a:r>
            <a:r>
              <a:rPr lang="it-IT" sz="1200" dirty="0" err="1"/>
              <a:t>exclusion</a:t>
            </a:r>
            <a:r>
              <a:rPr lang="it-IT" sz="1200" dirty="0"/>
              <a:t> </a:t>
            </a:r>
            <a:r>
              <a:rPr lang="it-IT" sz="1200" dirty="0" err="1"/>
              <a:t>criteria</a:t>
            </a:r>
            <a:r>
              <a:rPr lang="it-IT" sz="1200" dirty="0"/>
              <a:t> </a:t>
            </a:r>
            <a:r>
              <a:rPr lang="it-IT" sz="1200" dirty="0" err="1"/>
              <a:t>during</a:t>
            </a:r>
            <a:r>
              <a:rPr lang="it-IT" sz="1200" dirty="0"/>
              <a:t> NSCLC </a:t>
            </a:r>
            <a:r>
              <a:rPr lang="it-IT" sz="1200" dirty="0" err="1"/>
              <a:t>enrollment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1017312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Immagine che contiene schermata, diagramma, design&#10;&#10;Il contenuto generato dall'IA potrebbe non essere corretto.">
            <a:extLst>
              <a:ext uri="{FF2B5EF4-FFF2-40B4-BE49-F238E27FC236}">
                <a16:creationId xmlns:a16="http://schemas.microsoft.com/office/drawing/2014/main" id="{9778DD7C-F8A0-A7BA-5ED7-5384C18E0FA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66592" b="50211"/>
          <a:stretch/>
        </p:blipFill>
        <p:spPr>
          <a:xfrm>
            <a:off x="0" y="2421362"/>
            <a:ext cx="1673423" cy="1597769"/>
          </a:xfrm>
          <a:prstGeom prst="rect">
            <a:avLst/>
          </a:prstGeom>
        </p:spPr>
      </p:pic>
      <p:pic>
        <p:nvPicPr>
          <p:cNvPr id="5" name="Immagine 4" descr="Immagine che contiene schermata, diagramma, testo, design&#10;&#10;Il contenuto generato dall'IA potrebbe non essere corretto.">
            <a:extLst>
              <a:ext uri="{FF2B5EF4-FFF2-40B4-BE49-F238E27FC236}">
                <a16:creationId xmlns:a16="http://schemas.microsoft.com/office/drawing/2014/main" id="{C405DC6C-7090-28D8-08FD-E6DB378A2FD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557" t="68000" r="59804"/>
          <a:stretch/>
        </p:blipFill>
        <p:spPr>
          <a:xfrm>
            <a:off x="4503782" y="288590"/>
            <a:ext cx="1764204" cy="1597769"/>
          </a:xfrm>
          <a:prstGeom prst="rect">
            <a:avLst/>
          </a:prstGeom>
        </p:spPr>
      </p:pic>
      <p:pic>
        <p:nvPicPr>
          <p:cNvPr id="7" name="Immagine 6" descr="Immagine che contiene schermata, diagramma, design&#10;&#10;Il contenuto generato dall'IA potrebbe non essere corretto.">
            <a:extLst>
              <a:ext uri="{FF2B5EF4-FFF2-40B4-BE49-F238E27FC236}">
                <a16:creationId xmlns:a16="http://schemas.microsoft.com/office/drawing/2014/main" id="{F59C0085-DD4F-BE98-4887-6A124774640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408" r="33184" b="50211"/>
          <a:stretch/>
        </p:blipFill>
        <p:spPr>
          <a:xfrm>
            <a:off x="3018741" y="2418200"/>
            <a:ext cx="1673423" cy="1597769"/>
          </a:xfrm>
          <a:prstGeom prst="rect">
            <a:avLst/>
          </a:prstGeom>
        </p:spPr>
      </p:pic>
      <p:pic>
        <p:nvPicPr>
          <p:cNvPr id="8" name="Immagine 7" descr="Immagine che contiene schermata, diagramma, design&#10;&#10;Il contenuto generato dall'IA potrebbe non essere corretto.">
            <a:extLst>
              <a:ext uri="{FF2B5EF4-FFF2-40B4-BE49-F238E27FC236}">
                <a16:creationId xmlns:a16="http://schemas.microsoft.com/office/drawing/2014/main" id="{43AED657-0AD8-E555-4794-91CE3B19C25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6816" b="50211"/>
          <a:stretch/>
        </p:blipFill>
        <p:spPr>
          <a:xfrm>
            <a:off x="4512756" y="1726303"/>
            <a:ext cx="1662175" cy="1597769"/>
          </a:xfrm>
          <a:prstGeom prst="rect">
            <a:avLst/>
          </a:prstGeom>
        </p:spPr>
      </p:pic>
      <p:pic>
        <p:nvPicPr>
          <p:cNvPr id="10" name="Immagine 9" descr="Immagine che contiene schermata, diagramma, design&#10;&#10;Il contenuto generato dall'IA potrebbe non essere corretto.">
            <a:extLst>
              <a:ext uri="{FF2B5EF4-FFF2-40B4-BE49-F238E27FC236}">
                <a16:creationId xmlns:a16="http://schemas.microsoft.com/office/drawing/2014/main" id="{00E1063F-9879-9E88-E2EA-BB702574281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49790" r="64780"/>
          <a:stretch/>
        </p:blipFill>
        <p:spPr>
          <a:xfrm>
            <a:off x="4559343" y="3813410"/>
            <a:ext cx="1764203" cy="1611277"/>
          </a:xfrm>
          <a:prstGeom prst="rect">
            <a:avLst/>
          </a:prstGeom>
        </p:spPr>
      </p:pic>
      <p:pic>
        <p:nvPicPr>
          <p:cNvPr id="11" name="Immagine 10" descr="Immagine che contiene schermata, diagramma, design&#10;&#10;Il contenuto generato dall'IA potrebbe non essere corretto.">
            <a:extLst>
              <a:ext uri="{FF2B5EF4-FFF2-40B4-BE49-F238E27FC236}">
                <a16:creationId xmlns:a16="http://schemas.microsoft.com/office/drawing/2014/main" id="{4B93EAA9-6710-955B-315F-8867E13413C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408" t="49790" r="31371"/>
          <a:stretch/>
        </p:blipFill>
        <p:spPr>
          <a:xfrm>
            <a:off x="6259593" y="4566138"/>
            <a:ext cx="1764203" cy="1611277"/>
          </a:xfrm>
          <a:prstGeom prst="rect">
            <a:avLst/>
          </a:prstGeom>
        </p:spPr>
      </p:pic>
      <p:pic>
        <p:nvPicPr>
          <p:cNvPr id="12" name="Immagine 11" descr="Immagine che contiene schermata, diagramma, design&#10;&#10;Il contenuto generato dall'IA potrebbe non essere corretto.">
            <a:extLst>
              <a:ext uri="{FF2B5EF4-FFF2-40B4-BE49-F238E27FC236}">
                <a16:creationId xmlns:a16="http://schemas.microsoft.com/office/drawing/2014/main" id="{063946D7-4F6A-5914-53E3-14AE4D7583C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6816" t="49790"/>
          <a:stretch/>
        </p:blipFill>
        <p:spPr>
          <a:xfrm>
            <a:off x="6204293" y="3044590"/>
            <a:ext cx="1662175" cy="1611277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1C382E00-0357-9D61-48C3-2CD25EC94E8A}"/>
              </a:ext>
            </a:extLst>
          </p:cNvPr>
          <p:cNvSpPr txBox="1"/>
          <p:nvPr/>
        </p:nvSpPr>
        <p:spPr>
          <a:xfrm>
            <a:off x="6069309" y="799911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FMO</a:t>
            </a:r>
          </a:p>
        </p:txBody>
      </p:sp>
      <p:cxnSp>
        <p:nvCxnSpPr>
          <p:cNvPr id="19" name="Connettore 1 18">
            <a:extLst>
              <a:ext uri="{FF2B5EF4-FFF2-40B4-BE49-F238E27FC236}">
                <a16:creationId xmlns:a16="http://schemas.microsoft.com/office/drawing/2014/main" id="{8C20AFE7-4DE5-589E-3CC2-34AEA3A4F854}"/>
              </a:ext>
            </a:extLst>
          </p:cNvPr>
          <p:cNvCxnSpPr/>
          <p:nvPr/>
        </p:nvCxnSpPr>
        <p:spPr>
          <a:xfrm>
            <a:off x="3855452" y="1726303"/>
            <a:ext cx="0" cy="59648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Connettore 2 20">
            <a:extLst>
              <a:ext uri="{FF2B5EF4-FFF2-40B4-BE49-F238E27FC236}">
                <a16:creationId xmlns:a16="http://schemas.microsoft.com/office/drawing/2014/main" id="{23A7BEDD-5698-1CBB-3642-20B6599D240D}"/>
              </a:ext>
            </a:extLst>
          </p:cNvPr>
          <p:cNvCxnSpPr/>
          <p:nvPr/>
        </p:nvCxnSpPr>
        <p:spPr>
          <a:xfrm>
            <a:off x="3855452" y="1726303"/>
            <a:ext cx="83671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5B5A8E81-63F5-F55C-BFBA-9690B4E48AFF}"/>
              </a:ext>
            </a:extLst>
          </p:cNvPr>
          <p:cNvSpPr txBox="1"/>
          <p:nvPr/>
        </p:nvSpPr>
        <p:spPr>
          <a:xfrm>
            <a:off x="6110920" y="2210715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D137 T </a:t>
            </a:r>
            <a:r>
              <a:rPr lang="it-IT" sz="1000" b="1" dirty="0" err="1"/>
              <a:t>cells</a:t>
            </a:r>
            <a:endParaRPr lang="it-IT" sz="1000" b="1" dirty="0"/>
          </a:p>
        </p:txBody>
      </p:sp>
      <p:cxnSp>
        <p:nvCxnSpPr>
          <p:cNvPr id="23" name="Connettore 1 22">
            <a:extLst>
              <a:ext uri="{FF2B5EF4-FFF2-40B4-BE49-F238E27FC236}">
                <a16:creationId xmlns:a16="http://schemas.microsoft.com/office/drawing/2014/main" id="{6D984E0D-A620-1786-00DD-60A05C8D38E1}"/>
              </a:ext>
            </a:extLst>
          </p:cNvPr>
          <p:cNvCxnSpPr/>
          <p:nvPr/>
        </p:nvCxnSpPr>
        <p:spPr>
          <a:xfrm>
            <a:off x="3858869" y="3969655"/>
            <a:ext cx="0" cy="59648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281F71A7-CE9D-7B63-1E7C-61CAA1C3E294}"/>
              </a:ext>
            </a:extLst>
          </p:cNvPr>
          <p:cNvCxnSpPr/>
          <p:nvPr/>
        </p:nvCxnSpPr>
        <p:spPr>
          <a:xfrm>
            <a:off x="3844942" y="4566498"/>
            <a:ext cx="83671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86764DE8-4A4D-5E86-6511-0AFC08E8C0B0}"/>
              </a:ext>
            </a:extLst>
          </p:cNvPr>
          <p:cNvSpPr txBox="1"/>
          <p:nvPr/>
        </p:nvSpPr>
        <p:spPr>
          <a:xfrm>
            <a:off x="7895830" y="3429000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D8CD137 T </a:t>
            </a:r>
            <a:r>
              <a:rPr lang="it-IT" sz="1000" b="1" dirty="0" err="1"/>
              <a:t>cells</a:t>
            </a:r>
            <a:endParaRPr lang="it-IT" sz="1000" b="1" dirty="0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AB031FA8-CE6E-15D7-5BCF-840547E6CA3A}"/>
              </a:ext>
            </a:extLst>
          </p:cNvPr>
          <p:cNvSpPr txBox="1"/>
          <p:nvPr/>
        </p:nvSpPr>
        <p:spPr>
          <a:xfrm>
            <a:off x="7901087" y="5147438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D4CD137 T </a:t>
            </a:r>
            <a:r>
              <a:rPr lang="it-IT" sz="1000" b="1" dirty="0" err="1"/>
              <a:t>cells</a:t>
            </a:r>
            <a:endParaRPr lang="it-IT" sz="1000" b="1" dirty="0"/>
          </a:p>
        </p:txBody>
      </p:sp>
      <p:cxnSp>
        <p:nvCxnSpPr>
          <p:cNvPr id="29" name="Connettore 2 28">
            <a:extLst>
              <a:ext uri="{FF2B5EF4-FFF2-40B4-BE49-F238E27FC236}">
                <a16:creationId xmlns:a16="http://schemas.microsoft.com/office/drawing/2014/main" id="{3B8DD418-BB58-C938-D70A-E7E735647765}"/>
              </a:ext>
            </a:extLst>
          </p:cNvPr>
          <p:cNvCxnSpPr/>
          <p:nvPr/>
        </p:nvCxnSpPr>
        <p:spPr>
          <a:xfrm>
            <a:off x="6069309" y="4141076"/>
            <a:ext cx="40505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Connettore 2 29">
            <a:extLst>
              <a:ext uri="{FF2B5EF4-FFF2-40B4-BE49-F238E27FC236}">
                <a16:creationId xmlns:a16="http://schemas.microsoft.com/office/drawing/2014/main" id="{657DBAFB-775A-4778-6D9D-AE61C2F414B9}"/>
              </a:ext>
            </a:extLst>
          </p:cNvPr>
          <p:cNvCxnSpPr/>
          <p:nvPr/>
        </p:nvCxnSpPr>
        <p:spPr>
          <a:xfrm>
            <a:off x="6074567" y="4861029"/>
            <a:ext cx="40505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85C5F08B-E828-57BA-BED8-7C6DCB2BA68B}"/>
              </a:ext>
            </a:extLst>
          </p:cNvPr>
          <p:cNvSpPr txBox="1"/>
          <p:nvPr/>
        </p:nvSpPr>
        <p:spPr>
          <a:xfrm>
            <a:off x="3384324" y="2536198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D3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AF3C4FA6-8F50-9B33-91C3-9DF300E1FFB2}"/>
              </a:ext>
            </a:extLst>
          </p:cNvPr>
          <p:cNvSpPr txBox="1"/>
          <p:nvPr/>
        </p:nvSpPr>
        <p:spPr>
          <a:xfrm>
            <a:off x="188997" y="6006746"/>
            <a:ext cx="118140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err="1"/>
              <a:t>Supplementary</a:t>
            </a:r>
            <a:r>
              <a:rPr lang="it-IT" sz="1000" b="1" dirty="0"/>
              <a:t> Figure S2: </a:t>
            </a:r>
            <a:r>
              <a:rPr lang="it-IT" sz="1000" b="1" dirty="0" err="1"/>
              <a:t>Cytofluorimetric</a:t>
            </a:r>
            <a:r>
              <a:rPr lang="it-IT" sz="1000" b="1" dirty="0"/>
              <a:t> </a:t>
            </a:r>
            <a:r>
              <a:rPr lang="it-IT" sz="1000" b="1" dirty="0" err="1"/>
              <a:t>analysis</a:t>
            </a:r>
            <a:r>
              <a:rPr lang="it-IT" sz="1000" b="1" dirty="0"/>
              <a:t> of CD137 T subsets. </a:t>
            </a:r>
            <a:r>
              <a:rPr lang="it-IT" sz="1000" dirty="0"/>
              <a:t>A. </a:t>
            </a:r>
            <a:r>
              <a:rPr lang="it-IT" sz="1000" dirty="0" err="1"/>
              <a:t>Cells</a:t>
            </a:r>
            <a:r>
              <a:rPr lang="it-IT" sz="1000" dirty="0"/>
              <a:t> </a:t>
            </a:r>
            <a:r>
              <a:rPr lang="it-IT" sz="1000" dirty="0" err="1"/>
              <a:t>were</a:t>
            </a:r>
            <a:r>
              <a:rPr lang="it-IT" sz="1000" dirty="0"/>
              <a:t> </a:t>
            </a:r>
            <a:r>
              <a:rPr lang="it-IT" sz="1000" dirty="0" err="1"/>
              <a:t>gated</a:t>
            </a:r>
            <a:r>
              <a:rPr lang="it-IT" sz="1000" dirty="0"/>
              <a:t> on </a:t>
            </a:r>
            <a:r>
              <a:rPr lang="it-IT" sz="1000" dirty="0" err="1"/>
              <a:t>lymphocytes</a:t>
            </a:r>
            <a:r>
              <a:rPr lang="it-IT" sz="1000" dirty="0"/>
              <a:t> by SSC-A and FSC-A, </a:t>
            </a:r>
            <a:r>
              <a:rPr lang="it-IT" sz="1000" dirty="0" err="1"/>
              <a:t>followed</a:t>
            </a:r>
            <a:r>
              <a:rPr lang="it-IT" sz="1000" dirty="0"/>
              <a:t> by live </a:t>
            </a:r>
            <a:r>
              <a:rPr lang="it-IT" sz="1000" dirty="0" err="1"/>
              <a:t>cells</a:t>
            </a:r>
            <a:r>
              <a:rPr lang="it-IT" sz="1000" dirty="0"/>
              <a:t> (live and </a:t>
            </a:r>
            <a:r>
              <a:rPr lang="it-IT" sz="1000" dirty="0" err="1"/>
              <a:t>death</a:t>
            </a:r>
            <a:r>
              <a:rPr lang="it-IT" sz="1000" dirty="0"/>
              <a:t>/FSC-A) and CD3+ </a:t>
            </a:r>
            <a:r>
              <a:rPr lang="it-IT" sz="1000" dirty="0" err="1"/>
              <a:t>cells</a:t>
            </a:r>
            <a:r>
              <a:rPr lang="it-IT" sz="1000" dirty="0"/>
              <a:t> by SSC/CD3. CD137 T </a:t>
            </a:r>
            <a:r>
              <a:rPr lang="it-IT" sz="1000" dirty="0" err="1"/>
              <a:t>cells</a:t>
            </a:r>
            <a:r>
              <a:rPr lang="it-IT" sz="1000" dirty="0"/>
              <a:t> </a:t>
            </a:r>
            <a:r>
              <a:rPr lang="it-IT" sz="1000" dirty="0" err="1"/>
              <a:t>were</a:t>
            </a:r>
            <a:r>
              <a:rPr lang="it-IT" sz="1000" dirty="0"/>
              <a:t> </a:t>
            </a:r>
            <a:r>
              <a:rPr lang="it-IT" sz="1000" dirty="0" err="1"/>
              <a:t>then</a:t>
            </a:r>
            <a:r>
              <a:rPr lang="it-IT" sz="1000" dirty="0"/>
              <a:t> </a:t>
            </a:r>
            <a:r>
              <a:rPr lang="it-IT" sz="1000" dirty="0" err="1"/>
              <a:t>selected</a:t>
            </a:r>
            <a:r>
              <a:rPr lang="it-IT" sz="1000" dirty="0"/>
              <a:t> </a:t>
            </a:r>
            <a:r>
              <a:rPr lang="it-IT" sz="1000" dirty="0" err="1"/>
              <a:t>as</a:t>
            </a:r>
            <a:r>
              <a:rPr lang="it-IT" sz="1000" dirty="0"/>
              <a:t> CD3+ and CD137+ </a:t>
            </a:r>
            <a:r>
              <a:rPr lang="it-IT" sz="1000" dirty="0" err="1"/>
              <a:t>cells</a:t>
            </a:r>
            <a:r>
              <a:rPr lang="it-IT" sz="1000" dirty="0"/>
              <a:t>. The CD4 and CD8 T </a:t>
            </a:r>
            <a:r>
              <a:rPr lang="it-IT" sz="1000" dirty="0" err="1"/>
              <a:t>cell</a:t>
            </a:r>
            <a:r>
              <a:rPr lang="it-IT" sz="1000" dirty="0"/>
              <a:t> </a:t>
            </a:r>
            <a:r>
              <a:rPr lang="it-IT" sz="1000" dirty="0" err="1"/>
              <a:t>subpopulations</a:t>
            </a:r>
            <a:r>
              <a:rPr lang="it-IT" sz="1000" dirty="0"/>
              <a:t> </a:t>
            </a:r>
            <a:r>
              <a:rPr lang="it-IT" sz="1000" dirty="0" err="1"/>
              <a:t>were</a:t>
            </a:r>
            <a:r>
              <a:rPr lang="it-IT" sz="1000" dirty="0"/>
              <a:t> </a:t>
            </a:r>
            <a:r>
              <a:rPr lang="it-IT" sz="1000" dirty="0" err="1"/>
              <a:t>identified</a:t>
            </a:r>
            <a:r>
              <a:rPr lang="it-IT" sz="1000" dirty="0"/>
              <a:t> </a:t>
            </a:r>
            <a:r>
              <a:rPr lang="it-IT" sz="1000" dirty="0" err="1"/>
              <a:t>as</a:t>
            </a:r>
            <a:r>
              <a:rPr lang="it-IT" sz="1000" dirty="0"/>
              <a:t> CD3+CD8- and CD+CD8+, </a:t>
            </a:r>
            <a:r>
              <a:rPr lang="it-IT" sz="1000" dirty="0" err="1"/>
              <a:t>respectively</a:t>
            </a:r>
            <a:r>
              <a:rPr lang="it-IT" sz="1000" dirty="0"/>
              <a:t>. </a:t>
            </a:r>
            <a:r>
              <a:rPr lang="it-IT" sz="1000" dirty="0" err="1"/>
              <a:t>Fluorescence</a:t>
            </a:r>
            <a:r>
              <a:rPr lang="it-IT" sz="1000" dirty="0"/>
              <a:t> </a:t>
            </a:r>
            <a:r>
              <a:rPr lang="it-IT" sz="1000" dirty="0" err="1"/>
              <a:t>minus</a:t>
            </a:r>
            <a:r>
              <a:rPr lang="it-IT" sz="1000" dirty="0"/>
              <a:t>-one (FMO) </a:t>
            </a:r>
            <a:r>
              <a:rPr lang="it-IT" sz="1000" dirty="0" err="1"/>
              <a:t>was</a:t>
            </a:r>
            <a:r>
              <a:rPr lang="it-IT" sz="1000" dirty="0"/>
              <a:t> </a:t>
            </a:r>
            <a:r>
              <a:rPr lang="it-IT" sz="1000" dirty="0" err="1"/>
              <a:t>performed</a:t>
            </a:r>
            <a:r>
              <a:rPr lang="it-IT" sz="1000" dirty="0"/>
              <a:t> </a:t>
            </a:r>
            <a:r>
              <a:rPr lang="it-IT" sz="1000" dirty="0" err="1"/>
              <a:t>using</a:t>
            </a:r>
            <a:r>
              <a:rPr lang="it-IT" sz="1000" dirty="0"/>
              <a:t> anti-human CD3, CD4, and CD8 </a:t>
            </a:r>
            <a:r>
              <a:rPr lang="it-IT" sz="1000" dirty="0" err="1"/>
              <a:t>monoclonal</a:t>
            </a:r>
            <a:r>
              <a:rPr lang="it-IT" sz="1000" dirty="0"/>
              <a:t> </a:t>
            </a:r>
            <a:r>
              <a:rPr lang="it-IT" sz="1000" dirty="0" err="1"/>
              <a:t>antibodies</a:t>
            </a:r>
            <a:r>
              <a:rPr lang="it-IT" sz="1000" dirty="0"/>
              <a:t> (</a:t>
            </a:r>
            <a:r>
              <a:rPr lang="it-IT" sz="1000" dirty="0" err="1"/>
              <a:t>MoAbs</a:t>
            </a:r>
            <a:r>
              <a:rPr lang="it-IT" sz="1000" dirty="0"/>
              <a:t>) </a:t>
            </a:r>
            <a:r>
              <a:rPr lang="it-IT" sz="1000" dirty="0" err="1"/>
              <a:t>without</a:t>
            </a:r>
            <a:r>
              <a:rPr lang="it-IT" sz="1000" dirty="0"/>
              <a:t> the anti-CD137 </a:t>
            </a:r>
            <a:r>
              <a:rPr lang="it-IT" sz="1000" dirty="0" err="1"/>
              <a:t>MoAb</a:t>
            </a:r>
            <a:r>
              <a:rPr lang="it-IT" sz="1000" dirty="0"/>
              <a:t>.</a:t>
            </a:r>
          </a:p>
          <a:p>
            <a:pPr algn="just"/>
            <a:endParaRPr lang="it-IT" sz="1000" dirty="0"/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F4A8A9AC-D80D-B92A-294E-FDA04BB3ECE9}"/>
              </a:ext>
            </a:extLst>
          </p:cNvPr>
          <p:cNvSpPr txBox="1"/>
          <p:nvPr/>
        </p:nvSpPr>
        <p:spPr>
          <a:xfrm>
            <a:off x="404197" y="2525187"/>
            <a:ext cx="9637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/>
              <a:t>Lymphocytes</a:t>
            </a:r>
            <a:endParaRPr lang="it-IT" sz="1000" b="1" dirty="0"/>
          </a:p>
        </p:txBody>
      </p:sp>
      <p:pic>
        <p:nvPicPr>
          <p:cNvPr id="4" name="Immagine 3" descr="Immagine che contiene schermata, Policromia, testo, Elementi grafici&#10;&#10;Il contenuto generato dall'IA potrebbe non essere corretto.">
            <a:extLst>
              <a:ext uri="{FF2B5EF4-FFF2-40B4-BE49-F238E27FC236}">
                <a16:creationId xmlns:a16="http://schemas.microsoft.com/office/drawing/2014/main" id="{ECE1299F-17C2-A5C2-6940-7EE54938F1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6378" y="2418200"/>
            <a:ext cx="1834209" cy="1596948"/>
          </a:xfrm>
          <a:prstGeom prst="rect">
            <a:avLst/>
          </a:prstGeom>
        </p:spPr>
      </p:pic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1788D2B1-44E9-DE9F-BFE1-8D3E61A66179}"/>
              </a:ext>
            </a:extLst>
          </p:cNvPr>
          <p:cNvSpPr txBox="1"/>
          <p:nvPr/>
        </p:nvSpPr>
        <p:spPr>
          <a:xfrm>
            <a:off x="1911890" y="2520786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Live </a:t>
            </a:r>
            <a:r>
              <a:rPr lang="it-IT" sz="1000" b="1" dirty="0" err="1"/>
              <a:t>cells</a:t>
            </a:r>
            <a:endParaRPr lang="it-IT" sz="1000" b="1" dirty="0"/>
          </a:p>
        </p:txBody>
      </p:sp>
    </p:spTree>
    <p:extLst>
      <p:ext uri="{BB962C8B-B14F-4D97-AF65-F5344CB8AC3E}">
        <p14:creationId xmlns:p14="http://schemas.microsoft.com/office/powerpoint/2010/main" val="21570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AAEFA446-162D-97A5-4787-0C066D1D56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6883" y="1971716"/>
            <a:ext cx="3540167" cy="2424772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2C31801D-7B6C-DBE6-ABA1-448470CBB8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0956" y="2031614"/>
            <a:ext cx="3540167" cy="2424772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E9DA10E6-2039-7BFB-AC84-983D9C249682}"/>
              </a:ext>
            </a:extLst>
          </p:cNvPr>
          <p:cNvSpPr txBox="1"/>
          <p:nvPr/>
        </p:nvSpPr>
        <p:spPr>
          <a:xfrm>
            <a:off x="1334530" y="4683211"/>
            <a:ext cx="93019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/>
              <a:t>Figure S3</a:t>
            </a:r>
            <a:r>
              <a:rPr lang="it-IT" sz="1200" dirty="0"/>
              <a:t>: Kaplan Meier </a:t>
            </a:r>
            <a:r>
              <a:rPr lang="it-IT" sz="1200" dirty="0" err="1"/>
              <a:t>curves</a:t>
            </a:r>
            <a:r>
              <a:rPr lang="it-IT" sz="1200" dirty="0"/>
              <a:t> of </a:t>
            </a:r>
            <a:r>
              <a:rPr lang="it-IT" sz="1200" dirty="0" err="1"/>
              <a:t>Progression</a:t>
            </a:r>
            <a:r>
              <a:rPr lang="it-IT" sz="1200" dirty="0"/>
              <a:t>-Free Survival (PFS) and Overall Survival (OS) of 27 NSCLC </a:t>
            </a:r>
            <a:r>
              <a:rPr lang="it-IT" sz="1200" dirty="0" err="1"/>
              <a:t>patients</a:t>
            </a:r>
            <a:r>
              <a:rPr lang="it-IT" sz="1200" dirty="0"/>
              <a:t> </a:t>
            </a:r>
            <a:r>
              <a:rPr lang="it-IT" sz="1200" dirty="0" err="1"/>
              <a:t>treated</a:t>
            </a:r>
            <a:r>
              <a:rPr lang="it-IT" sz="1200" dirty="0"/>
              <a:t> with anti-PD1 treatment with or </a:t>
            </a:r>
            <a:r>
              <a:rPr lang="it-IT" sz="1200" dirty="0" err="1"/>
              <a:t>without</a:t>
            </a:r>
            <a:r>
              <a:rPr lang="it-IT" sz="1200" dirty="0"/>
              <a:t> </a:t>
            </a:r>
            <a:r>
              <a:rPr lang="it-IT" sz="1200" dirty="0" err="1"/>
              <a:t>chemotherapy</a:t>
            </a:r>
            <a:r>
              <a:rPr lang="it-IT" sz="1200" dirty="0"/>
              <a:t>. The </a:t>
            </a:r>
            <a:r>
              <a:rPr lang="it-IT" sz="1100" dirty="0" err="1"/>
              <a:t>median</a:t>
            </a:r>
            <a:r>
              <a:rPr lang="it-IT" sz="1100" dirty="0"/>
              <a:t> PFS and OS </a:t>
            </a:r>
            <a:r>
              <a:rPr lang="it-IT" sz="1100" dirty="0" err="1"/>
              <a:t>correspond</a:t>
            </a:r>
            <a:r>
              <a:rPr lang="it-IT" sz="1100" dirty="0"/>
              <a:t> to 7 and 10 </a:t>
            </a:r>
            <a:r>
              <a:rPr lang="it-IT" sz="1100" dirty="0" err="1"/>
              <a:t>months</a:t>
            </a:r>
            <a:r>
              <a:rPr lang="it-IT" sz="1100" dirty="0"/>
              <a:t>, </a:t>
            </a:r>
            <a:r>
              <a:rPr lang="it-IT" sz="1100" dirty="0" err="1"/>
              <a:t>respectively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33081764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</TotalTime>
  <Words>216</Words>
  <Application>Microsoft Macintosh PowerPoint</Application>
  <PresentationFormat>Widescreen</PresentationFormat>
  <Paragraphs>29</Paragraphs>
  <Slides>3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iara Napoletano</dc:creator>
  <cp:lastModifiedBy>Chiara Napoletano</cp:lastModifiedBy>
  <cp:revision>3</cp:revision>
  <dcterms:created xsi:type="dcterms:W3CDTF">2025-02-24T09:32:02Z</dcterms:created>
  <dcterms:modified xsi:type="dcterms:W3CDTF">2025-03-07T11:30:02Z</dcterms:modified>
</cp:coreProperties>
</file>